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3320713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5" autoAdjust="0"/>
    <p:restoredTop sz="94660"/>
  </p:normalViewPr>
  <p:slideViewPr>
    <p:cSldViewPr snapToGrid="0">
      <p:cViewPr>
        <p:scale>
          <a:sx n="80" d="100"/>
          <a:sy n="80" d="100"/>
        </p:scale>
        <p:origin x="-570" y="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Manz_2021\Taxus%20FWDW.od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Manz_2021\Taxus%20FWDW.od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Manz_2021\Taxus%20growth%20factor%207.od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Manz_2021\Taxus%20PCV.od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1_Aktuell\02_Publikationen\A_Cellular_Biotech\Manz_2021\Taxus%20PCV.od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Tabelle1!$J$3:$J$18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xVal>
          <c:yVal>
            <c:numRef>
              <c:f>Tabelle1!$K$3:$K$18</c:f>
              <c:numCache>
                <c:formatCode>0.00</c:formatCode>
                <c:ptCount val="16"/>
                <c:pt idx="0">
                  <c:v>0.75800000000000023</c:v>
                </c:pt>
                <c:pt idx="1">
                  <c:v>0.7629999999999999</c:v>
                </c:pt>
                <c:pt idx="2">
                  <c:v>0.89999999999999991</c:v>
                </c:pt>
                <c:pt idx="3">
                  <c:v>1.0129999999999999</c:v>
                </c:pt>
                <c:pt idx="4">
                  <c:v>1.2209999999999999</c:v>
                </c:pt>
                <c:pt idx="5">
                  <c:v>1.7150000000000003</c:v>
                </c:pt>
                <c:pt idx="6">
                  <c:v>1.6760000000000002</c:v>
                </c:pt>
                <c:pt idx="7">
                  <c:v>1.9700000000000002</c:v>
                </c:pt>
                <c:pt idx="8">
                  <c:v>2.6549999999999998</c:v>
                </c:pt>
                <c:pt idx="9">
                  <c:v>2.9909999999999997</c:v>
                </c:pt>
                <c:pt idx="10">
                  <c:v>2.0680000000000001</c:v>
                </c:pt>
                <c:pt idx="11">
                  <c:v>3.3010000000000002</c:v>
                </c:pt>
                <c:pt idx="12">
                  <c:v>4.3580000000000005</c:v>
                </c:pt>
                <c:pt idx="13">
                  <c:v>6.2209999999999992</c:v>
                </c:pt>
                <c:pt idx="14">
                  <c:v>5.29</c:v>
                </c:pt>
                <c:pt idx="15">
                  <c:v>5.528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DEB-49D4-BF31-C4D2A1501A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81704767"/>
        <c:axId val="1081715167"/>
      </c:scatterChart>
      <c:valAx>
        <c:axId val="1081704767"/>
        <c:scaling>
          <c:orientation val="minMax"/>
          <c:max val="1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1715167"/>
        <c:crosses val="autoZero"/>
        <c:crossBetween val="midCat"/>
        <c:majorUnit val="5"/>
      </c:valAx>
      <c:valAx>
        <c:axId val="10817151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17047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Tabelle1!$N$2</c:f>
              <c:strCache>
                <c:ptCount val="1"/>
                <c:pt idx="0">
                  <c:v>dw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bg1"/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xVal>
            <c:numRef>
              <c:f>Tabelle1!$M$3:$M$18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xVal>
          <c:yVal>
            <c:numRef>
              <c:f>Tabelle1!$N$3:$N$18</c:f>
              <c:numCache>
                <c:formatCode>0.00</c:formatCode>
                <c:ptCount val="16"/>
                <c:pt idx="0">
                  <c:v>3.400000000000003E-2</c:v>
                </c:pt>
                <c:pt idx="1">
                  <c:v>3.5000000000000142E-2</c:v>
                </c:pt>
                <c:pt idx="2">
                  <c:v>3.300000000000014E-2</c:v>
                </c:pt>
                <c:pt idx="3">
                  <c:v>4.3000000000000149E-2</c:v>
                </c:pt>
                <c:pt idx="4">
                  <c:v>5.500000000000016E-2</c:v>
                </c:pt>
                <c:pt idx="5">
                  <c:v>8.3000000000000185E-2</c:v>
                </c:pt>
                <c:pt idx="6">
                  <c:v>7.2999999999999954E-2</c:v>
                </c:pt>
                <c:pt idx="7">
                  <c:v>8.7999999999999634E-2</c:v>
                </c:pt>
                <c:pt idx="8">
                  <c:v>0.1080000000000001</c:v>
                </c:pt>
                <c:pt idx="9">
                  <c:v>0.12299999999999978</c:v>
                </c:pt>
                <c:pt idx="10">
                  <c:v>0.10499999999999998</c:v>
                </c:pt>
                <c:pt idx="11">
                  <c:v>0.13400000000000034</c:v>
                </c:pt>
                <c:pt idx="12">
                  <c:v>0.16199999999999992</c:v>
                </c:pt>
                <c:pt idx="13">
                  <c:v>0.17300000000000004</c:v>
                </c:pt>
                <c:pt idx="14">
                  <c:v>0.16100000000000003</c:v>
                </c:pt>
                <c:pt idx="15">
                  <c:v>0.165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C3C-4A03-A1CD-8279D61757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23666559"/>
        <c:axId val="1029715455"/>
      </c:scatterChart>
      <c:valAx>
        <c:axId val="1023666559"/>
        <c:scaling>
          <c:orientation val="minMax"/>
          <c:max val="15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" sourceLinked="0"/>
        <c:majorTickMark val="none"/>
        <c:minorTickMark val="none"/>
        <c:tickLblPos val="nextTo"/>
        <c:crossAx val="1029715455"/>
        <c:crosses val="autoZero"/>
        <c:crossBetween val="midCat"/>
        <c:majorUnit val="5"/>
      </c:valAx>
      <c:valAx>
        <c:axId val="1029715455"/>
        <c:scaling>
          <c:orientation val="minMax"/>
        </c:scaling>
        <c:delete val="0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bg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23666559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Tabelle1!$J$1</c:f>
              <c:strCache>
                <c:ptCount val="1"/>
                <c:pt idx="0">
                  <c:v>mean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Tabelle1!$K$2:$K$26</c:f>
                <c:numCache>
                  <c:formatCode>General</c:formatCode>
                  <c:ptCount val="25"/>
                  <c:pt idx="0">
                    <c:v>0.13333333333333341</c:v>
                  </c:pt>
                  <c:pt idx="1">
                    <c:v>9.9999999999999853E-2</c:v>
                  </c:pt>
                  <c:pt idx="2">
                    <c:v>0.16666666666666674</c:v>
                  </c:pt>
                  <c:pt idx="3">
                    <c:v>0.23333333333333336</c:v>
                  </c:pt>
                  <c:pt idx="4">
                    <c:v>0.14999999999999991</c:v>
                  </c:pt>
                  <c:pt idx="5">
                    <c:v>3.3333333333333215E-2</c:v>
                  </c:pt>
                  <c:pt idx="6">
                    <c:v>0.35000000000000198</c:v>
                  </c:pt>
                  <c:pt idx="7">
                    <c:v>0.2</c:v>
                  </c:pt>
                  <c:pt idx="8">
                    <c:v>0</c:v>
                  </c:pt>
                  <c:pt idx="9">
                    <c:v>0.11666666666666668</c:v>
                  </c:pt>
                  <c:pt idx="10">
                    <c:v>0.14999999999999991</c:v>
                  </c:pt>
                  <c:pt idx="11">
                    <c:v>0.1333333333333333</c:v>
                  </c:pt>
                  <c:pt idx="12">
                    <c:v>0</c:v>
                  </c:pt>
                  <c:pt idx="13">
                    <c:v>0.26666666666666589</c:v>
                  </c:pt>
                  <c:pt idx="14">
                    <c:v>5.0000000000000044E-2</c:v>
                  </c:pt>
                  <c:pt idx="15">
                    <c:v>8.8888888888889003E-2</c:v>
                  </c:pt>
                  <c:pt idx="16">
                    <c:v>0.30000000000000121</c:v>
                  </c:pt>
                  <c:pt idx="17">
                    <c:v>0.21666666666666656</c:v>
                  </c:pt>
                  <c:pt idx="18">
                    <c:v>0.15555555555555589</c:v>
                  </c:pt>
                  <c:pt idx="19">
                    <c:v>0.37777777777777621</c:v>
                  </c:pt>
                  <c:pt idx="20">
                    <c:v>0.11111111111111116</c:v>
                  </c:pt>
                  <c:pt idx="21">
                    <c:v>0.30000000000000121</c:v>
                  </c:pt>
                  <c:pt idx="22">
                    <c:v>0.25555555555555576</c:v>
                  </c:pt>
                  <c:pt idx="23">
                    <c:v>0.35555555555555357</c:v>
                  </c:pt>
                  <c:pt idx="24">
                    <c:v>0.14444444444444438</c:v>
                  </c:pt>
                </c:numCache>
              </c:numRef>
            </c:plus>
            <c:minus>
              <c:numRef>
                <c:f>Tabelle1!$K$2:$K$26</c:f>
                <c:numCache>
                  <c:formatCode>General</c:formatCode>
                  <c:ptCount val="25"/>
                  <c:pt idx="0">
                    <c:v>0.13333333333333341</c:v>
                  </c:pt>
                  <c:pt idx="1">
                    <c:v>9.9999999999999853E-2</c:v>
                  </c:pt>
                  <c:pt idx="2">
                    <c:v>0.16666666666666674</c:v>
                  </c:pt>
                  <c:pt idx="3">
                    <c:v>0.23333333333333336</c:v>
                  </c:pt>
                  <c:pt idx="4">
                    <c:v>0.14999999999999991</c:v>
                  </c:pt>
                  <c:pt idx="5">
                    <c:v>3.3333333333333215E-2</c:v>
                  </c:pt>
                  <c:pt idx="6">
                    <c:v>0.35000000000000198</c:v>
                  </c:pt>
                  <c:pt idx="7">
                    <c:v>0.2</c:v>
                  </c:pt>
                  <c:pt idx="8">
                    <c:v>0</c:v>
                  </c:pt>
                  <c:pt idx="9">
                    <c:v>0.11666666666666668</c:v>
                  </c:pt>
                  <c:pt idx="10">
                    <c:v>0.14999999999999991</c:v>
                  </c:pt>
                  <c:pt idx="11">
                    <c:v>0.1333333333333333</c:v>
                  </c:pt>
                  <c:pt idx="12">
                    <c:v>0</c:v>
                  </c:pt>
                  <c:pt idx="13">
                    <c:v>0.26666666666666589</c:v>
                  </c:pt>
                  <c:pt idx="14">
                    <c:v>5.0000000000000044E-2</c:v>
                  </c:pt>
                  <c:pt idx="15">
                    <c:v>8.8888888888889003E-2</c:v>
                  </c:pt>
                  <c:pt idx="16">
                    <c:v>0.30000000000000121</c:v>
                  </c:pt>
                  <c:pt idx="17">
                    <c:v>0.21666666666666656</c:v>
                  </c:pt>
                  <c:pt idx="18">
                    <c:v>0.15555555555555589</c:v>
                  </c:pt>
                  <c:pt idx="19">
                    <c:v>0.37777777777777621</c:v>
                  </c:pt>
                  <c:pt idx="20">
                    <c:v>0.11111111111111116</c:v>
                  </c:pt>
                  <c:pt idx="21">
                    <c:v>0.30000000000000121</c:v>
                  </c:pt>
                  <c:pt idx="22">
                    <c:v>0.25555555555555576</c:v>
                  </c:pt>
                  <c:pt idx="23">
                    <c:v>0.35555555555555357</c:v>
                  </c:pt>
                  <c:pt idx="24">
                    <c:v>0.144444444444444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Tabelle1!$J$2:$J$26</c:f>
              <c:numCache>
                <c:formatCode>0.00</c:formatCode>
                <c:ptCount val="25"/>
                <c:pt idx="0">
                  <c:v>1.9333333333333336</c:v>
                </c:pt>
                <c:pt idx="1">
                  <c:v>2.333333333333333</c:v>
                </c:pt>
                <c:pt idx="2">
                  <c:v>2.4000000000000004</c:v>
                </c:pt>
                <c:pt idx="3">
                  <c:v>2.5666666666666669</c:v>
                </c:pt>
                <c:pt idx="4">
                  <c:v>2.4833333333333334</c:v>
                </c:pt>
                <c:pt idx="5">
                  <c:v>2.1666666666666665</c:v>
                </c:pt>
                <c:pt idx="6">
                  <c:v>2.3833333333333329</c:v>
                </c:pt>
                <c:pt idx="7">
                  <c:v>2.0666666666666664</c:v>
                </c:pt>
                <c:pt idx="8">
                  <c:v>2.2666666666666666</c:v>
                </c:pt>
                <c:pt idx="9">
                  <c:v>2.25</c:v>
                </c:pt>
                <c:pt idx="10">
                  <c:v>2.25</c:v>
                </c:pt>
                <c:pt idx="11">
                  <c:v>2.3666666666666667</c:v>
                </c:pt>
                <c:pt idx="12">
                  <c:v>2.0666666666666669</c:v>
                </c:pt>
                <c:pt idx="13">
                  <c:v>2.1333333333333333</c:v>
                </c:pt>
                <c:pt idx="14">
                  <c:v>2.1833333333333336</c:v>
                </c:pt>
                <c:pt idx="15">
                  <c:v>2.2888888888888888</c:v>
                </c:pt>
                <c:pt idx="16">
                  <c:v>2.0333333333333332</c:v>
                </c:pt>
                <c:pt idx="17">
                  <c:v>2.25</c:v>
                </c:pt>
                <c:pt idx="18">
                  <c:v>2.3555555555555556</c:v>
                </c:pt>
                <c:pt idx="19">
                  <c:v>2.4000000000000004</c:v>
                </c:pt>
                <c:pt idx="20">
                  <c:v>2.7333333333333334</c:v>
                </c:pt>
                <c:pt idx="21">
                  <c:v>2.6333333333333333</c:v>
                </c:pt>
                <c:pt idx="22">
                  <c:v>2.7</c:v>
                </c:pt>
                <c:pt idx="23">
                  <c:v>2.3777777777777782</c:v>
                </c:pt>
                <c:pt idx="24">
                  <c:v>2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5CC-44F6-9690-AFDAE76CA8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5182384"/>
        <c:axId val="1795169488"/>
      </c:scatterChart>
      <c:valAx>
        <c:axId val="1795182384"/>
        <c:scaling>
          <c:orientation val="minMax"/>
          <c:max val="1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5169488"/>
        <c:crosses val="autoZero"/>
        <c:crossBetween val="midCat"/>
        <c:majorUnit val="5"/>
      </c:valAx>
      <c:valAx>
        <c:axId val="1795169488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5182384"/>
        <c:crosses val="autoZero"/>
        <c:crossBetween val="midCat"/>
        <c:majorUnit val="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Tabelle1!$A$9:$P$9</c:f>
                <c:numCache>
                  <c:formatCode>General</c:formatCode>
                  <c:ptCount val="16"/>
                  <c:pt idx="0">
                    <c:v>7.0710678118654779E-2</c:v>
                  </c:pt>
                  <c:pt idx="1">
                    <c:v>0</c:v>
                  </c:pt>
                  <c:pt idx="2">
                    <c:v>1.7677669529663664E-2</c:v>
                  </c:pt>
                  <c:pt idx="3">
                    <c:v>0.10606601717798309</c:v>
                  </c:pt>
                  <c:pt idx="4">
                    <c:v>0.17677669529663687</c:v>
                  </c:pt>
                  <c:pt idx="5">
                    <c:v>0.30052038200428194</c:v>
                  </c:pt>
                  <c:pt idx="6">
                    <c:v>0.14142135623730948</c:v>
                  </c:pt>
                  <c:pt idx="7">
                    <c:v>0.17677669529663687</c:v>
                  </c:pt>
                  <c:pt idx="8">
                    <c:v>0.17677669529663687</c:v>
                  </c:pt>
                  <c:pt idx="9">
                    <c:v>0.2651650429449553</c:v>
                  </c:pt>
                  <c:pt idx="10">
                    <c:v>0.17677669529663687</c:v>
                  </c:pt>
                  <c:pt idx="11">
                    <c:v>8.8388347648318433E-2</c:v>
                  </c:pt>
                  <c:pt idx="12">
                    <c:v>8.8388347648318433E-2</c:v>
                  </c:pt>
                  <c:pt idx="13">
                    <c:v>3.5355339059327251E-2</c:v>
                  </c:pt>
                  <c:pt idx="14">
                    <c:v>7.0710678118654807E-2</c:v>
                  </c:pt>
                  <c:pt idx="15">
                    <c:v>3.5355339059327563E-2</c:v>
                  </c:pt>
                </c:numCache>
              </c:numRef>
            </c:plus>
            <c:minus>
              <c:numRef>
                <c:f>Tabelle1!$A$9:$P$9</c:f>
                <c:numCache>
                  <c:formatCode>General</c:formatCode>
                  <c:ptCount val="16"/>
                  <c:pt idx="0">
                    <c:v>7.0710678118654779E-2</c:v>
                  </c:pt>
                  <c:pt idx="1">
                    <c:v>0</c:v>
                  </c:pt>
                  <c:pt idx="2">
                    <c:v>1.7677669529663664E-2</c:v>
                  </c:pt>
                  <c:pt idx="3">
                    <c:v>0.10606601717798309</c:v>
                  </c:pt>
                  <c:pt idx="4">
                    <c:v>0.17677669529663687</c:v>
                  </c:pt>
                  <c:pt idx="5">
                    <c:v>0.30052038200428194</c:v>
                  </c:pt>
                  <c:pt idx="6">
                    <c:v>0.14142135623730948</c:v>
                  </c:pt>
                  <c:pt idx="7">
                    <c:v>0.17677669529663687</c:v>
                  </c:pt>
                  <c:pt idx="8">
                    <c:v>0.17677669529663687</c:v>
                  </c:pt>
                  <c:pt idx="9">
                    <c:v>0.2651650429449553</c:v>
                  </c:pt>
                  <c:pt idx="10">
                    <c:v>0.17677669529663687</c:v>
                  </c:pt>
                  <c:pt idx="11">
                    <c:v>8.8388347648318433E-2</c:v>
                  </c:pt>
                  <c:pt idx="12">
                    <c:v>8.8388347648318433E-2</c:v>
                  </c:pt>
                  <c:pt idx="13">
                    <c:v>3.5355339059327251E-2</c:v>
                  </c:pt>
                  <c:pt idx="14">
                    <c:v>7.0710678118654807E-2</c:v>
                  </c:pt>
                  <c:pt idx="15">
                    <c:v>3.53553390593275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Tabelle1!$A$12:$P$12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xVal>
          <c:yVal>
            <c:numRef>
              <c:f>Tabelle1!$A$13:$P$13</c:f>
              <c:numCache>
                <c:formatCode>General</c:formatCode>
                <c:ptCount val="16"/>
                <c:pt idx="0">
                  <c:v>0.75</c:v>
                </c:pt>
                <c:pt idx="1">
                  <c:v>0.8</c:v>
                </c:pt>
                <c:pt idx="2">
                  <c:v>0.82499999999999996</c:v>
                </c:pt>
                <c:pt idx="3">
                  <c:v>1.4</c:v>
                </c:pt>
                <c:pt idx="4">
                  <c:v>1.75</c:v>
                </c:pt>
                <c:pt idx="5">
                  <c:v>2.3250000000000002</c:v>
                </c:pt>
                <c:pt idx="6">
                  <c:v>2.0999999999999996</c:v>
                </c:pt>
                <c:pt idx="7">
                  <c:v>2.25</c:v>
                </c:pt>
                <c:pt idx="8">
                  <c:v>2.25</c:v>
                </c:pt>
                <c:pt idx="9">
                  <c:v>2.375</c:v>
                </c:pt>
                <c:pt idx="10">
                  <c:v>2.25</c:v>
                </c:pt>
                <c:pt idx="11">
                  <c:v>4.125</c:v>
                </c:pt>
                <c:pt idx="12">
                  <c:v>3.625</c:v>
                </c:pt>
                <c:pt idx="13">
                  <c:v>4.95</c:v>
                </c:pt>
                <c:pt idx="14">
                  <c:v>5.9</c:v>
                </c:pt>
                <c:pt idx="15">
                  <c:v>6.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59D-4137-9982-923331FAAB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10125967"/>
        <c:axId val="910126383"/>
      </c:scatterChart>
      <c:valAx>
        <c:axId val="910125967"/>
        <c:scaling>
          <c:orientation val="minMax"/>
          <c:max val="1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0126383"/>
        <c:crosses val="autoZero"/>
        <c:crossBetween val="midCat"/>
        <c:majorUnit val="5"/>
      </c:valAx>
      <c:valAx>
        <c:axId val="9101263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01259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xMode val="edge"/>
          <c:yMode val="edge"/>
          <c:x val="1.6729401923881223E-2"/>
          <c:y val="2.5497594050743658E-2"/>
          <c:w val="0.95817649519029691"/>
          <c:h val="0.95135425780110827"/>
        </c:manualLayout>
      </c:layout>
      <c:scatterChart>
        <c:scatterStyle val="lineMarker"/>
        <c:varyColors val="0"/>
        <c:ser>
          <c:idx val="0"/>
          <c:order val="0"/>
          <c:spPr>
            <a:ln>
              <a:noFill/>
            </a:ln>
          </c:spPr>
          <c:marker>
            <c:symbol val="triangle"/>
            <c:size val="6"/>
            <c:spPr>
              <a:solidFill>
                <a:srgbClr val="FFFFFF"/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xVal>
            <c:numRef>
              <c:f>Tabelle1!$A$15:$P$15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xVal>
          <c:yVal>
            <c:numRef>
              <c:f>Tabelle1!$A$16:$P$16</c:f>
              <c:numCache>
                <c:formatCode>General</c:formatCode>
                <c:ptCount val="16"/>
                <c:pt idx="0">
                  <c:v>1.34</c:v>
                </c:pt>
                <c:pt idx="1">
                  <c:v>1.21</c:v>
                </c:pt>
                <c:pt idx="2">
                  <c:v>1.19</c:v>
                </c:pt>
                <c:pt idx="3">
                  <c:v>1.1499999999999999</c:v>
                </c:pt>
                <c:pt idx="4">
                  <c:v>1.05</c:v>
                </c:pt>
                <c:pt idx="5">
                  <c:v>1.01</c:v>
                </c:pt>
                <c:pt idx="6">
                  <c:v>0.98</c:v>
                </c:pt>
                <c:pt idx="7">
                  <c:v>0.95</c:v>
                </c:pt>
                <c:pt idx="8">
                  <c:v>0.81</c:v>
                </c:pt>
                <c:pt idx="9">
                  <c:v>0.8</c:v>
                </c:pt>
                <c:pt idx="10">
                  <c:v>0.72</c:v>
                </c:pt>
                <c:pt idx="11">
                  <c:v>0.63</c:v>
                </c:pt>
                <c:pt idx="12">
                  <c:v>0.42</c:v>
                </c:pt>
                <c:pt idx="13">
                  <c:v>0.41</c:v>
                </c:pt>
                <c:pt idx="14">
                  <c:v>0.42</c:v>
                </c:pt>
                <c:pt idx="15">
                  <c:v>0.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FFA-42A4-895C-A6D2A38870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8998288"/>
        <c:axId val="749000784"/>
      </c:scatterChart>
      <c:valAx>
        <c:axId val="749000784"/>
        <c:scaling>
          <c:orientation val="minMax"/>
          <c:max val="1.4"/>
          <c:min val="0"/>
        </c:scaling>
        <c:delete val="0"/>
        <c:axPos val="r"/>
        <c:majorGridlines>
          <c:spPr>
            <a:ln w="9528" cap="flat">
              <a:solidFill>
                <a:srgbClr val="D9D9D9"/>
              </a:solidFill>
              <a:prstDash val="solid"/>
              <a:round/>
            </a:ln>
          </c:spPr>
        </c:majorGridlines>
        <c:numFmt formatCode="#,##0.0" sourceLinked="0"/>
        <c:majorTickMark val="none"/>
        <c:minorTickMark val="none"/>
        <c:tickLblPos val="nextTo"/>
        <c:spPr>
          <a:noFill/>
          <a:ln w="9528" cap="flat">
            <a:solidFill>
              <a:srgbClr val="BFBFBF"/>
            </a:solidFill>
            <a:prstDash val="solid"/>
            <a:round/>
          </a:ln>
        </c:spPr>
        <c:txPr>
          <a:bodyPr lIns="0" tIns="0" rIns="0" bIns="0"/>
          <a:lstStyle/>
          <a:p>
            <a:pPr marL="0" marR="0" indent="0" defTabSz="91440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1800" b="0" i="0" u="none" strike="noStrike" kern="1200" baseline="0">
                <a:solidFill>
                  <a:schemeClr val="bg1">
                    <a:lumMod val="65000"/>
                  </a:schemeClr>
                </a:solidFill>
                <a:latin typeface="Calibri"/>
              </a:defRPr>
            </a:pPr>
            <a:endParaRPr lang="en-US"/>
          </a:p>
        </c:txPr>
        <c:crossAx val="748998288"/>
        <c:crosses val="max"/>
        <c:crossBetween val="midCat"/>
        <c:majorUnit val="0.2"/>
      </c:valAx>
      <c:valAx>
        <c:axId val="748998288"/>
        <c:scaling>
          <c:orientation val="minMax"/>
          <c:max val="15"/>
        </c:scaling>
        <c:delete val="1"/>
        <c:axPos val="b"/>
        <c:majorGridlines>
          <c:spPr>
            <a:ln w="9528" cap="flat">
              <a:solidFill>
                <a:srgbClr val="D9D9D9"/>
              </a:solidFill>
              <a:prstDash val="solid"/>
              <a:round/>
            </a:ln>
          </c:spPr>
        </c:majorGridlines>
        <c:numFmt formatCode="General" sourceLinked="1"/>
        <c:majorTickMark val="none"/>
        <c:minorTickMark val="none"/>
        <c:tickLblPos val="nextTo"/>
        <c:crossAx val="749000784"/>
        <c:crosses val="autoZero"/>
        <c:crossBetween val="midCat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 w="9528" cap="flat">
      <a:solidFill>
        <a:schemeClr val="bg1"/>
      </a:solidFill>
      <a:prstDash val="solid"/>
      <a:round/>
    </a:ln>
  </c:spPr>
  <c:txPr>
    <a:bodyPr lIns="0" tIns="0" rIns="0" bIns="0"/>
    <a:lstStyle/>
    <a:p>
      <a:pPr marL="0" marR="0" indent="0" defTabSz="914400" fontAlgn="auto" hangingPunct="1">
        <a:lnSpc>
          <a:spcPct val="100000"/>
        </a:lnSpc>
        <a:spcBef>
          <a:spcPts val="0"/>
        </a:spcBef>
        <a:spcAft>
          <a:spcPts val="0"/>
        </a:spcAft>
        <a:tabLst/>
        <a:defRPr lang="de-DE" sz="1000" b="0" i="0" u="none" strike="noStrike" kern="1200" baseline="0">
          <a:solidFill>
            <a:srgbClr val="000000"/>
          </a:solidFill>
          <a:latin typeface="Calibri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5089" y="1119505"/>
            <a:ext cx="9990535" cy="2381521"/>
          </a:xfrm>
        </p:spPr>
        <p:txBody>
          <a:bodyPr anchor="b"/>
          <a:lstStyle>
            <a:lvl1pPr algn="ctr">
              <a:defRPr sz="598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3592866"/>
            <a:ext cx="9990535" cy="1651546"/>
          </a:xfrm>
        </p:spPr>
        <p:txBody>
          <a:bodyPr/>
          <a:lstStyle>
            <a:lvl1pPr marL="0" indent="0" algn="ctr">
              <a:buNone/>
              <a:defRPr sz="2394"/>
            </a:lvl1pPr>
            <a:lvl2pPr marL="456057" indent="0" algn="ctr">
              <a:buNone/>
              <a:defRPr sz="1995"/>
            </a:lvl2pPr>
            <a:lvl3pPr marL="912114" indent="0" algn="ctr">
              <a:buNone/>
              <a:defRPr sz="1795"/>
            </a:lvl3pPr>
            <a:lvl4pPr marL="1368171" indent="0" algn="ctr">
              <a:buNone/>
              <a:defRPr sz="1596"/>
            </a:lvl4pPr>
            <a:lvl5pPr marL="1824228" indent="0" algn="ctr">
              <a:buNone/>
              <a:defRPr sz="1596"/>
            </a:lvl5pPr>
            <a:lvl6pPr marL="2280285" indent="0" algn="ctr">
              <a:buNone/>
              <a:defRPr sz="1596"/>
            </a:lvl6pPr>
            <a:lvl7pPr marL="2736342" indent="0" algn="ctr">
              <a:buNone/>
              <a:defRPr sz="1596"/>
            </a:lvl7pPr>
            <a:lvl8pPr marL="3192399" indent="0" algn="ctr">
              <a:buNone/>
              <a:defRPr sz="1596"/>
            </a:lvl8pPr>
            <a:lvl9pPr marL="3648456" indent="0" algn="ctr">
              <a:buNone/>
              <a:defRPr sz="1596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593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2127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5" y="364195"/>
            <a:ext cx="2872279" cy="5797040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799" y="364195"/>
            <a:ext cx="8450327" cy="5797040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4277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303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1" y="1705385"/>
            <a:ext cx="11489115" cy="2845473"/>
          </a:xfrm>
        </p:spPr>
        <p:txBody>
          <a:bodyPr anchor="b"/>
          <a:lstStyle>
            <a:lvl1pPr>
              <a:defRPr sz="598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1" y="4577778"/>
            <a:ext cx="11489115" cy="1496367"/>
          </a:xfrm>
        </p:spPr>
        <p:txBody>
          <a:bodyPr/>
          <a:lstStyle>
            <a:lvl1pPr marL="0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1pPr>
            <a:lvl2pPr marL="456057" indent="0">
              <a:buNone/>
              <a:defRPr sz="1995">
                <a:solidFill>
                  <a:schemeClr val="tx1">
                    <a:tint val="75000"/>
                  </a:schemeClr>
                </a:solidFill>
              </a:defRPr>
            </a:lvl2pPr>
            <a:lvl3pPr marL="912114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3pPr>
            <a:lvl4pPr marL="1368171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4pPr>
            <a:lvl5pPr marL="1824228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5pPr>
            <a:lvl6pPr marL="2280285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6pPr>
            <a:lvl7pPr marL="2736342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7pPr>
            <a:lvl8pPr marL="3192399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8pPr>
            <a:lvl9pPr marL="3648456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6856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1820976"/>
            <a:ext cx="5661303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1820976"/>
            <a:ext cx="5661303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0936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364196"/>
            <a:ext cx="11489115" cy="1322188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5" y="1676882"/>
            <a:ext cx="5635285" cy="821814"/>
          </a:xfrm>
        </p:spPr>
        <p:txBody>
          <a:bodyPr anchor="b"/>
          <a:lstStyle>
            <a:lvl1pPr marL="0" indent="0">
              <a:buNone/>
              <a:defRPr sz="2394" b="1"/>
            </a:lvl1pPr>
            <a:lvl2pPr marL="456057" indent="0">
              <a:buNone/>
              <a:defRPr sz="1995" b="1"/>
            </a:lvl2pPr>
            <a:lvl3pPr marL="912114" indent="0">
              <a:buNone/>
              <a:defRPr sz="1795" b="1"/>
            </a:lvl3pPr>
            <a:lvl4pPr marL="1368171" indent="0">
              <a:buNone/>
              <a:defRPr sz="1596" b="1"/>
            </a:lvl4pPr>
            <a:lvl5pPr marL="1824228" indent="0">
              <a:buNone/>
              <a:defRPr sz="1596" b="1"/>
            </a:lvl5pPr>
            <a:lvl6pPr marL="2280285" indent="0">
              <a:buNone/>
              <a:defRPr sz="1596" b="1"/>
            </a:lvl6pPr>
            <a:lvl7pPr marL="2736342" indent="0">
              <a:buNone/>
              <a:defRPr sz="1596" b="1"/>
            </a:lvl7pPr>
            <a:lvl8pPr marL="3192399" indent="0">
              <a:buNone/>
              <a:defRPr sz="1596" b="1"/>
            </a:lvl8pPr>
            <a:lvl9pPr marL="3648456" indent="0">
              <a:buNone/>
              <a:defRPr sz="1596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5" y="2498697"/>
            <a:ext cx="5635285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1" y="1676882"/>
            <a:ext cx="5663038" cy="821814"/>
          </a:xfrm>
        </p:spPr>
        <p:txBody>
          <a:bodyPr anchor="b"/>
          <a:lstStyle>
            <a:lvl1pPr marL="0" indent="0">
              <a:buNone/>
              <a:defRPr sz="2394" b="1"/>
            </a:lvl1pPr>
            <a:lvl2pPr marL="456057" indent="0">
              <a:buNone/>
              <a:defRPr sz="1995" b="1"/>
            </a:lvl2pPr>
            <a:lvl3pPr marL="912114" indent="0">
              <a:buNone/>
              <a:defRPr sz="1795" b="1"/>
            </a:lvl3pPr>
            <a:lvl4pPr marL="1368171" indent="0">
              <a:buNone/>
              <a:defRPr sz="1596" b="1"/>
            </a:lvl4pPr>
            <a:lvl5pPr marL="1824228" indent="0">
              <a:buNone/>
              <a:defRPr sz="1596" b="1"/>
            </a:lvl5pPr>
            <a:lvl6pPr marL="2280285" indent="0">
              <a:buNone/>
              <a:defRPr sz="1596" b="1"/>
            </a:lvl6pPr>
            <a:lvl7pPr marL="2736342" indent="0">
              <a:buNone/>
              <a:defRPr sz="1596" b="1"/>
            </a:lvl7pPr>
            <a:lvl8pPr marL="3192399" indent="0">
              <a:buNone/>
              <a:defRPr sz="1596" b="1"/>
            </a:lvl8pPr>
            <a:lvl9pPr marL="3648456" indent="0">
              <a:buNone/>
              <a:defRPr sz="1596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1" y="2498697"/>
            <a:ext cx="5663038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301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8982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982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456036"/>
            <a:ext cx="4296276" cy="1596126"/>
          </a:xfrm>
        </p:spPr>
        <p:txBody>
          <a:bodyPr anchor="b"/>
          <a:lstStyle>
            <a:lvl1pPr>
              <a:defRPr sz="319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984911"/>
            <a:ext cx="6743611" cy="4861216"/>
          </a:xfrm>
        </p:spPr>
        <p:txBody>
          <a:bodyPr/>
          <a:lstStyle>
            <a:lvl1pPr>
              <a:defRPr sz="3192"/>
            </a:lvl1pPr>
            <a:lvl2pPr>
              <a:defRPr sz="2793"/>
            </a:lvl2pPr>
            <a:lvl3pPr>
              <a:defRPr sz="2394"/>
            </a:lvl3pPr>
            <a:lvl4pPr>
              <a:defRPr sz="1995"/>
            </a:lvl4pPr>
            <a:lvl5pPr>
              <a:defRPr sz="1995"/>
            </a:lvl5pPr>
            <a:lvl6pPr>
              <a:defRPr sz="1995"/>
            </a:lvl6pPr>
            <a:lvl7pPr>
              <a:defRPr sz="1995"/>
            </a:lvl7pPr>
            <a:lvl8pPr>
              <a:defRPr sz="1995"/>
            </a:lvl8pPr>
            <a:lvl9pPr>
              <a:defRPr sz="199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052161"/>
            <a:ext cx="4296276" cy="3801883"/>
          </a:xfrm>
        </p:spPr>
        <p:txBody>
          <a:bodyPr/>
          <a:lstStyle>
            <a:lvl1pPr marL="0" indent="0">
              <a:buNone/>
              <a:defRPr sz="1596"/>
            </a:lvl1pPr>
            <a:lvl2pPr marL="456057" indent="0">
              <a:buNone/>
              <a:defRPr sz="1397"/>
            </a:lvl2pPr>
            <a:lvl3pPr marL="912114" indent="0">
              <a:buNone/>
              <a:defRPr sz="1197"/>
            </a:lvl3pPr>
            <a:lvl4pPr marL="1368171" indent="0">
              <a:buNone/>
              <a:defRPr sz="998"/>
            </a:lvl4pPr>
            <a:lvl5pPr marL="1824228" indent="0">
              <a:buNone/>
              <a:defRPr sz="998"/>
            </a:lvl5pPr>
            <a:lvl6pPr marL="2280285" indent="0">
              <a:buNone/>
              <a:defRPr sz="998"/>
            </a:lvl6pPr>
            <a:lvl7pPr marL="2736342" indent="0">
              <a:buNone/>
              <a:defRPr sz="998"/>
            </a:lvl7pPr>
            <a:lvl8pPr marL="3192399" indent="0">
              <a:buNone/>
              <a:defRPr sz="998"/>
            </a:lvl8pPr>
            <a:lvl9pPr marL="3648456" indent="0">
              <a:buNone/>
              <a:defRPr sz="998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803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456036"/>
            <a:ext cx="4296276" cy="1596126"/>
          </a:xfrm>
        </p:spPr>
        <p:txBody>
          <a:bodyPr anchor="b"/>
          <a:lstStyle>
            <a:lvl1pPr>
              <a:defRPr sz="319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984911"/>
            <a:ext cx="6743611" cy="4861216"/>
          </a:xfrm>
        </p:spPr>
        <p:txBody>
          <a:bodyPr anchor="t"/>
          <a:lstStyle>
            <a:lvl1pPr marL="0" indent="0">
              <a:buNone/>
              <a:defRPr sz="3192"/>
            </a:lvl1pPr>
            <a:lvl2pPr marL="456057" indent="0">
              <a:buNone/>
              <a:defRPr sz="2793"/>
            </a:lvl2pPr>
            <a:lvl3pPr marL="912114" indent="0">
              <a:buNone/>
              <a:defRPr sz="2394"/>
            </a:lvl3pPr>
            <a:lvl4pPr marL="1368171" indent="0">
              <a:buNone/>
              <a:defRPr sz="1995"/>
            </a:lvl4pPr>
            <a:lvl5pPr marL="1824228" indent="0">
              <a:buNone/>
              <a:defRPr sz="1995"/>
            </a:lvl5pPr>
            <a:lvl6pPr marL="2280285" indent="0">
              <a:buNone/>
              <a:defRPr sz="1995"/>
            </a:lvl6pPr>
            <a:lvl7pPr marL="2736342" indent="0">
              <a:buNone/>
              <a:defRPr sz="1995"/>
            </a:lvl7pPr>
            <a:lvl8pPr marL="3192399" indent="0">
              <a:buNone/>
              <a:defRPr sz="1995"/>
            </a:lvl8pPr>
            <a:lvl9pPr marL="3648456" indent="0">
              <a:buNone/>
              <a:defRPr sz="199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052161"/>
            <a:ext cx="4296276" cy="3801883"/>
          </a:xfrm>
        </p:spPr>
        <p:txBody>
          <a:bodyPr/>
          <a:lstStyle>
            <a:lvl1pPr marL="0" indent="0">
              <a:buNone/>
              <a:defRPr sz="1596"/>
            </a:lvl1pPr>
            <a:lvl2pPr marL="456057" indent="0">
              <a:buNone/>
              <a:defRPr sz="1397"/>
            </a:lvl2pPr>
            <a:lvl3pPr marL="912114" indent="0">
              <a:buNone/>
              <a:defRPr sz="1197"/>
            </a:lvl3pPr>
            <a:lvl4pPr marL="1368171" indent="0">
              <a:buNone/>
              <a:defRPr sz="998"/>
            </a:lvl4pPr>
            <a:lvl5pPr marL="1824228" indent="0">
              <a:buNone/>
              <a:defRPr sz="998"/>
            </a:lvl5pPr>
            <a:lvl6pPr marL="2280285" indent="0">
              <a:buNone/>
              <a:defRPr sz="998"/>
            </a:lvl6pPr>
            <a:lvl7pPr marL="2736342" indent="0">
              <a:buNone/>
              <a:defRPr sz="998"/>
            </a:lvl7pPr>
            <a:lvl8pPr marL="3192399" indent="0">
              <a:buNone/>
              <a:defRPr sz="998"/>
            </a:lvl8pPr>
            <a:lvl9pPr marL="3648456" indent="0">
              <a:buNone/>
              <a:defRPr sz="998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4935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364196"/>
            <a:ext cx="11489115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1820976"/>
            <a:ext cx="11489115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6340166"/>
            <a:ext cx="299716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BBC1C-EE62-4864-AB6C-13A4EA3B3AC6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6340166"/>
            <a:ext cx="4495741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6340166"/>
            <a:ext cx="299716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B2BA0-4E1C-4858-937D-DF98A52A48A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884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2114" rtl="0" eaLnBrk="1" latinLnBrk="0" hangingPunct="1">
        <a:lnSpc>
          <a:spcPct val="90000"/>
        </a:lnSpc>
        <a:spcBef>
          <a:spcPct val="0"/>
        </a:spcBef>
        <a:buNone/>
        <a:defRPr sz="43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029" indent="-228029" algn="l" defTabSz="912114" rtl="0" eaLnBrk="1" latinLnBrk="0" hangingPunct="1">
        <a:lnSpc>
          <a:spcPct val="90000"/>
        </a:lnSpc>
        <a:spcBef>
          <a:spcPts val="998"/>
        </a:spcBef>
        <a:buFont typeface="Arial" panose="020B0604020202020204" pitchFamily="34" charset="0"/>
        <a:buChar char="•"/>
        <a:defRPr sz="2793" kern="1200">
          <a:solidFill>
            <a:schemeClr val="tx1"/>
          </a:solidFill>
          <a:latin typeface="+mn-lt"/>
          <a:ea typeface="+mn-ea"/>
          <a:cs typeface="+mn-cs"/>
        </a:defRPr>
      </a:lvl1pPr>
      <a:lvl2pPr marL="684086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394" kern="1200">
          <a:solidFill>
            <a:schemeClr val="tx1"/>
          </a:solidFill>
          <a:latin typeface="+mn-lt"/>
          <a:ea typeface="+mn-ea"/>
          <a:cs typeface="+mn-cs"/>
        </a:defRPr>
      </a:lvl2pPr>
      <a:lvl3pPr marL="1140143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995" kern="1200">
          <a:solidFill>
            <a:schemeClr val="tx1"/>
          </a:solidFill>
          <a:latin typeface="+mn-lt"/>
          <a:ea typeface="+mn-ea"/>
          <a:cs typeface="+mn-cs"/>
        </a:defRPr>
      </a:lvl3pPr>
      <a:lvl4pPr marL="1596200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4pPr>
      <a:lvl5pPr marL="2052257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5pPr>
      <a:lvl6pPr marL="2508314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6pPr>
      <a:lvl7pPr marL="2964371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7pPr>
      <a:lvl8pPr marL="3420428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8pPr>
      <a:lvl9pPr marL="3876485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1pPr>
      <a:lvl2pPr marL="456057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912114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3pPr>
      <a:lvl4pPr marL="1368171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4pPr>
      <a:lvl5pPr marL="1824228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5pPr>
      <a:lvl6pPr marL="2280285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6pPr>
      <a:lvl7pPr marL="2736342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7pPr>
      <a:lvl8pPr marL="3192399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8pPr>
      <a:lvl9pPr marL="3648456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feld 61"/>
          <p:cNvSpPr txBox="1"/>
          <p:nvPr/>
        </p:nvSpPr>
        <p:spPr>
          <a:xfrm>
            <a:off x="1374969" y="4027298"/>
            <a:ext cx="10190895" cy="819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82" b="1" dirty="0" err="1"/>
              <a:t>Suppl</a:t>
            </a:r>
            <a:r>
              <a:rPr lang="de-DE" sz="1182" b="1" dirty="0"/>
              <a:t>. Fig. S1.</a:t>
            </a:r>
            <a:r>
              <a:rPr lang="de-DE" sz="1182" dirty="0"/>
              <a:t> Temporal </a:t>
            </a:r>
            <a:r>
              <a:rPr lang="de-DE" sz="1182" dirty="0" err="1"/>
              <a:t>dynamics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dirty="0" err="1"/>
              <a:t>the</a:t>
            </a:r>
            <a:r>
              <a:rPr lang="de-DE" sz="1182" dirty="0"/>
              <a:t> </a:t>
            </a:r>
            <a:r>
              <a:rPr lang="de-DE" sz="1182" dirty="0" err="1"/>
              <a:t>culture</a:t>
            </a:r>
            <a:r>
              <a:rPr lang="de-DE" sz="1182" dirty="0"/>
              <a:t> </a:t>
            </a:r>
            <a:r>
              <a:rPr lang="de-DE" sz="1182" dirty="0" err="1"/>
              <a:t>cycle</a:t>
            </a:r>
            <a:r>
              <a:rPr lang="de-DE" sz="1182" dirty="0"/>
              <a:t> in </a:t>
            </a:r>
            <a:r>
              <a:rPr lang="de-DE" sz="1182" dirty="0" err="1"/>
              <a:t>suspension</a:t>
            </a:r>
            <a:r>
              <a:rPr lang="de-DE" sz="1182" dirty="0"/>
              <a:t> </a:t>
            </a:r>
            <a:r>
              <a:rPr lang="de-DE" sz="1182" dirty="0" err="1"/>
              <a:t>cells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i="1" dirty="0"/>
              <a:t>Taxus </a:t>
            </a:r>
            <a:r>
              <a:rPr lang="de-DE" sz="1182" i="1" dirty="0" err="1"/>
              <a:t>brevifolia</a:t>
            </a:r>
            <a:r>
              <a:rPr lang="de-DE" sz="1182" dirty="0"/>
              <a:t>. </a:t>
            </a:r>
            <a:r>
              <a:rPr lang="de-DE" sz="1182" b="1" dirty="0"/>
              <a:t>A </a:t>
            </a:r>
            <a:r>
              <a:rPr lang="de-DE" sz="1182" dirty="0"/>
              <a:t>Growth </a:t>
            </a:r>
            <a:r>
              <a:rPr lang="de-DE" sz="1182" dirty="0" err="1"/>
              <a:t>index</a:t>
            </a:r>
            <a:r>
              <a:rPr lang="de-DE" sz="1182" dirty="0"/>
              <a:t> (</a:t>
            </a:r>
            <a:r>
              <a:rPr lang="de-DE" sz="1182" dirty="0" err="1"/>
              <a:t>ratio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dirty="0" err="1"/>
              <a:t>fresh</a:t>
            </a:r>
            <a:r>
              <a:rPr lang="de-DE" sz="1182" dirty="0"/>
              <a:t> </a:t>
            </a:r>
            <a:r>
              <a:rPr lang="de-DE" sz="1182" dirty="0" err="1"/>
              <a:t>weight</a:t>
            </a:r>
            <a:r>
              <a:rPr lang="de-DE" sz="1182" dirty="0"/>
              <a:t> at </a:t>
            </a:r>
            <a:r>
              <a:rPr lang="de-DE" sz="1182" dirty="0" err="1"/>
              <a:t>the</a:t>
            </a:r>
            <a:r>
              <a:rPr lang="de-DE" sz="1182" dirty="0"/>
              <a:t> end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dirty="0" err="1"/>
              <a:t>the</a:t>
            </a:r>
            <a:r>
              <a:rPr lang="de-DE" sz="1182" dirty="0"/>
              <a:t> </a:t>
            </a:r>
            <a:r>
              <a:rPr lang="de-DE" sz="1182" dirty="0" err="1"/>
              <a:t>culture</a:t>
            </a:r>
            <a:r>
              <a:rPr lang="de-DE" sz="1182" dirty="0"/>
              <a:t> </a:t>
            </a:r>
            <a:r>
              <a:rPr lang="de-DE" sz="1182" dirty="0" err="1"/>
              <a:t>cycle</a:t>
            </a:r>
            <a:r>
              <a:rPr lang="de-DE" sz="1182" dirty="0"/>
              <a:t> </a:t>
            </a:r>
            <a:r>
              <a:rPr lang="de-DE" sz="1182" dirty="0" err="1"/>
              <a:t>over</a:t>
            </a:r>
            <a:r>
              <a:rPr lang="de-DE" sz="1182" dirty="0"/>
              <a:t> </a:t>
            </a:r>
            <a:r>
              <a:rPr lang="de-DE" sz="1182" dirty="0" err="1"/>
              <a:t>that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dirty="0" err="1"/>
              <a:t>the</a:t>
            </a:r>
            <a:r>
              <a:rPr lang="de-DE" sz="1182" dirty="0"/>
              <a:t> initial </a:t>
            </a:r>
            <a:r>
              <a:rPr lang="de-DE" sz="1182" dirty="0" err="1"/>
              <a:t>inoculum</a:t>
            </a:r>
            <a:r>
              <a:rPr lang="de-DE" sz="1182" dirty="0"/>
              <a:t>) </a:t>
            </a:r>
            <a:r>
              <a:rPr lang="de-DE" sz="1182" dirty="0" err="1"/>
              <a:t>during</a:t>
            </a:r>
            <a:r>
              <a:rPr lang="de-DE" sz="1182" dirty="0"/>
              <a:t> </a:t>
            </a:r>
            <a:r>
              <a:rPr lang="de-DE" sz="1182" dirty="0" smtClean="0"/>
              <a:t>15 </a:t>
            </a:r>
            <a:r>
              <a:rPr lang="de-DE" sz="1182" dirty="0"/>
              <a:t>subsequent </a:t>
            </a:r>
            <a:r>
              <a:rPr lang="de-DE" sz="1182" dirty="0" err="1"/>
              <a:t>cycles</a:t>
            </a:r>
            <a:r>
              <a:rPr lang="de-DE" sz="1182" dirty="0"/>
              <a:t>. </a:t>
            </a:r>
            <a:r>
              <a:rPr lang="de-DE" sz="1182" b="1" dirty="0"/>
              <a:t>B</a:t>
            </a:r>
            <a:r>
              <a:rPr lang="de-DE" sz="1182" dirty="0"/>
              <a:t> </a:t>
            </a:r>
            <a:r>
              <a:rPr lang="de-DE" sz="1182" dirty="0" err="1"/>
              <a:t>Exemplary</a:t>
            </a:r>
            <a:r>
              <a:rPr lang="de-DE" sz="1182" dirty="0"/>
              <a:t> time </a:t>
            </a:r>
            <a:r>
              <a:rPr lang="de-DE" sz="1182" dirty="0" err="1"/>
              <a:t>course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dirty="0" err="1"/>
              <a:t>fresh</a:t>
            </a:r>
            <a:r>
              <a:rPr lang="de-DE" sz="1182" dirty="0"/>
              <a:t> (</a:t>
            </a:r>
            <a:r>
              <a:rPr lang="de-DE" sz="1182" dirty="0" err="1"/>
              <a:t>black</a:t>
            </a:r>
            <a:r>
              <a:rPr lang="de-DE" sz="1182" dirty="0"/>
              <a:t> solid </a:t>
            </a:r>
            <a:r>
              <a:rPr lang="de-DE" sz="1182" dirty="0" err="1"/>
              <a:t>curve</a:t>
            </a:r>
            <a:r>
              <a:rPr lang="de-DE" sz="1182" dirty="0"/>
              <a:t>) and dry </a:t>
            </a:r>
            <a:r>
              <a:rPr lang="de-DE" sz="1182" dirty="0" err="1"/>
              <a:t>weight</a:t>
            </a:r>
            <a:r>
              <a:rPr lang="de-DE" sz="1182" dirty="0"/>
              <a:t> (</a:t>
            </a:r>
            <a:r>
              <a:rPr lang="de-DE" sz="1182" dirty="0" err="1"/>
              <a:t>grey</a:t>
            </a:r>
            <a:r>
              <a:rPr lang="de-DE" sz="1182" dirty="0"/>
              <a:t> </a:t>
            </a:r>
            <a:r>
              <a:rPr lang="de-DE" sz="1182" dirty="0" err="1"/>
              <a:t>dashsed</a:t>
            </a:r>
            <a:r>
              <a:rPr lang="de-DE" sz="1182" dirty="0"/>
              <a:t> </a:t>
            </a:r>
            <a:r>
              <a:rPr lang="de-DE" sz="1182" dirty="0" err="1"/>
              <a:t>curve</a:t>
            </a:r>
            <a:r>
              <a:rPr lang="de-DE" sz="1182" dirty="0"/>
              <a:t>) </a:t>
            </a:r>
            <a:r>
              <a:rPr lang="de-DE" sz="1182" dirty="0" err="1"/>
              <a:t>over</a:t>
            </a:r>
            <a:r>
              <a:rPr lang="de-DE" sz="1182" dirty="0"/>
              <a:t> </a:t>
            </a:r>
            <a:r>
              <a:rPr lang="de-DE" sz="1182" dirty="0" err="1"/>
              <a:t>the</a:t>
            </a:r>
            <a:r>
              <a:rPr lang="de-DE" sz="1182" dirty="0"/>
              <a:t> time after </a:t>
            </a:r>
            <a:r>
              <a:rPr lang="de-DE" sz="1182" dirty="0" err="1"/>
              <a:t>subcultivation</a:t>
            </a:r>
            <a:r>
              <a:rPr lang="de-DE" sz="1182" dirty="0"/>
              <a:t>. </a:t>
            </a:r>
            <a:r>
              <a:rPr lang="de-DE" sz="1182" b="1" dirty="0"/>
              <a:t>C</a:t>
            </a:r>
            <a:r>
              <a:rPr lang="de-DE" sz="1182" dirty="0"/>
              <a:t> </a:t>
            </a:r>
            <a:r>
              <a:rPr lang="de-DE" sz="1182" dirty="0" err="1"/>
              <a:t>Exemplary</a:t>
            </a:r>
            <a:r>
              <a:rPr lang="de-DE" sz="1182" dirty="0"/>
              <a:t> time </a:t>
            </a:r>
            <a:r>
              <a:rPr lang="de-DE" sz="1182" dirty="0" err="1"/>
              <a:t>course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</a:t>
            </a:r>
            <a:r>
              <a:rPr lang="de-DE" sz="1182" dirty="0" err="1"/>
              <a:t>Packed</a:t>
            </a:r>
            <a:r>
              <a:rPr lang="de-DE" sz="1182" dirty="0"/>
              <a:t> </a:t>
            </a:r>
            <a:r>
              <a:rPr lang="de-DE" sz="1182" dirty="0" err="1"/>
              <a:t>Cell</a:t>
            </a:r>
            <a:r>
              <a:rPr lang="de-DE" sz="1182" dirty="0"/>
              <a:t> Volume (PCV) </a:t>
            </a:r>
            <a:r>
              <a:rPr lang="de-DE" sz="1182" dirty="0" err="1"/>
              <a:t>using</a:t>
            </a:r>
            <a:r>
              <a:rPr lang="de-DE" sz="1182" dirty="0"/>
              <a:t> a </a:t>
            </a:r>
            <a:r>
              <a:rPr lang="de-DE" sz="1182" dirty="0" err="1"/>
              <a:t>probing</a:t>
            </a:r>
            <a:r>
              <a:rPr lang="de-DE" sz="1182" dirty="0"/>
              <a:t> </a:t>
            </a:r>
            <a:r>
              <a:rPr lang="de-DE" sz="1182" dirty="0" err="1"/>
              <a:t>volume</a:t>
            </a:r>
            <a:r>
              <a:rPr lang="de-DE" sz="1182" dirty="0"/>
              <a:t> </a:t>
            </a:r>
            <a:r>
              <a:rPr lang="de-DE" sz="1182" dirty="0" err="1"/>
              <a:t>of</a:t>
            </a:r>
            <a:r>
              <a:rPr lang="de-DE" sz="1182" dirty="0"/>
              <a:t> 10 ml </a:t>
            </a:r>
            <a:r>
              <a:rPr lang="de-DE" sz="1182" dirty="0" err="1"/>
              <a:t>suspension</a:t>
            </a:r>
            <a:r>
              <a:rPr lang="de-DE" sz="1182" dirty="0"/>
              <a:t> (</a:t>
            </a:r>
            <a:r>
              <a:rPr lang="de-DE" sz="1182" dirty="0" err="1"/>
              <a:t>black</a:t>
            </a:r>
            <a:r>
              <a:rPr lang="de-DE" sz="1182" dirty="0"/>
              <a:t> solid </a:t>
            </a:r>
            <a:r>
              <a:rPr lang="de-DE" sz="1182" dirty="0" err="1"/>
              <a:t>curve</a:t>
            </a:r>
            <a:r>
              <a:rPr lang="de-DE" sz="1182" dirty="0"/>
              <a:t>) and residual </a:t>
            </a:r>
            <a:r>
              <a:rPr lang="de-DE" sz="1182" dirty="0" err="1"/>
              <a:t>sugar</a:t>
            </a:r>
            <a:r>
              <a:rPr lang="de-DE" sz="1182" dirty="0"/>
              <a:t> </a:t>
            </a:r>
            <a:r>
              <a:rPr lang="de-DE" sz="1182" dirty="0" err="1"/>
              <a:t>content</a:t>
            </a:r>
            <a:r>
              <a:rPr lang="de-DE" sz="1182" dirty="0"/>
              <a:t> in </a:t>
            </a:r>
            <a:r>
              <a:rPr lang="de-DE" sz="1182" dirty="0" err="1"/>
              <a:t>the</a:t>
            </a:r>
            <a:r>
              <a:rPr lang="de-DE" sz="1182" dirty="0"/>
              <a:t> medium </a:t>
            </a:r>
            <a:r>
              <a:rPr lang="de-DE" sz="1182" dirty="0" err="1"/>
              <a:t>as</a:t>
            </a:r>
            <a:r>
              <a:rPr lang="de-DE" sz="1182" dirty="0"/>
              <a:t> </a:t>
            </a:r>
            <a:r>
              <a:rPr lang="de-DE" sz="1182" dirty="0" err="1"/>
              <a:t>determined</a:t>
            </a:r>
            <a:r>
              <a:rPr lang="de-DE" sz="1182" dirty="0"/>
              <a:t> </a:t>
            </a:r>
            <a:r>
              <a:rPr lang="de-DE" sz="1182" dirty="0" err="1"/>
              <a:t>by</a:t>
            </a:r>
            <a:r>
              <a:rPr lang="de-DE" sz="1182" dirty="0"/>
              <a:t> a </a:t>
            </a:r>
            <a:r>
              <a:rPr lang="de-DE" sz="1182" dirty="0" err="1"/>
              <a:t>refractometer</a:t>
            </a:r>
            <a:r>
              <a:rPr lang="de-DE" sz="1182" dirty="0"/>
              <a:t> (</a:t>
            </a:r>
            <a:r>
              <a:rPr lang="de-DE" sz="1182" dirty="0" err="1"/>
              <a:t>grey</a:t>
            </a:r>
            <a:r>
              <a:rPr lang="de-DE" sz="1182" dirty="0"/>
              <a:t> </a:t>
            </a:r>
            <a:r>
              <a:rPr lang="de-DE" sz="1182" dirty="0" err="1"/>
              <a:t>dashed</a:t>
            </a:r>
            <a:r>
              <a:rPr lang="de-DE" sz="1182" dirty="0"/>
              <a:t> </a:t>
            </a:r>
            <a:r>
              <a:rPr lang="de-DE" sz="1182" dirty="0" err="1"/>
              <a:t>curve</a:t>
            </a:r>
            <a:r>
              <a:rPr lang="de-DE" sz="1182" dirty="0"/>
              <a:t>).</a:t>
            </a:r>
            <a:endParaRPr lang="en-GB" sz="1182" dirty="0"/>
          </a:p>
        </p:txBody>
      </p:sp>
      <p:graphicFrame>
        <p:nvGraphicFramePr>
          <p:cNvPr id="52" name="Diagramm 51">
            <a:extLst>
              <a:ext uri="{FF2B5EF4-FFF2-40B4-BE49-F238E27FC236}">
                <a16:creationId xmlns:a16="http://schemas.microsoft.com/office/drawing/2014/main" id="{F91CD1D7-E33F-4508-9375-D32ECDB2B2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2262325"/>
              </p:ext>
            </p:extLst>
          </p:nvPr>
        </p:nvGraphicFramePr>
        <p:xfrm>
          <a:off x="4825173" y="1214910"/>
          <a:ext cx="2463658" cy="2316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5" name="Diagramm 54">
            <a:extLst>
              <a:ext uri="{FF2B5EF4-FFF2-40B4-BE49-F238E27FC236}">
                <a16:creationId xmlns:a16="http://schemas.microsoft.com/office/drawing/2014/main" id="{5EE470A8-9488-4195-9818-FFFE77AED8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6395679"/>
              </p:ext>
            </p:extLst>
          </p:nvPr>
        </p:nvGraphicFramePr>
        <p:xfrm>
          <a:off x="5097559" y="1214911"/>
          <a:ext cx="2627010" cy="20197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Freihandform: Form 9">
            <a:extLst>
              <a:ext uri="{FF2B5EF4-FFF2-40B4-BE49-F238E27FC236}">
                <a16:creationId xmlns:a16="http://schemas.microsoft.com/office/drawing/2014/main" id="{1D2C3DCB-4FB6-46EE-874E-CDD4AD72DB29}"/>
              </a:ext>
            </a:extLst>
          </p:cNvPr>
          <p:cNvSpPr/>
          <p:nvPr/>
        </p:nvSpPr>
        <p:spPr>
          <a:xfrm>
            <a:off x="5209358" y="1820612"/>
            <a:ext cx="1859460" cy="1117792"/>
          </a:xfrm>
          <a:custGeom>
            <a:avLst/>
            <a:gdLst>
              <a:gd name="connsiteX0" fmla="*/ 0 w 2201663"/>
              <a:gd name="connsiteY0" fmla="*/ 1326718 h 1330017"/>
              <a:gd name="connsiteX1" fmla="*/ 381740 w 2201663"/>
              <a:gd name="connsiteY1" fmla="*/ 1291208 h 1330017"/>
              <a:gd name="connsiteX2" fmla="*/ 923278 w 2201663"/>
              <a:gd name="connsiteY2" fmla="*/ 1051510 h 1330017"/>
              <a:gd name="connsiteX3" fmla="*/ 1695635 w 2201663"/>
              <a:gd name="connsiteY3" fmla="*/ 288031 h 1330017"/>
              <a:gd name="connsiteX4" fmla="*/ 1935333 w 2201663"/>
              <a:gd name="connsiteY4" fmla="*/ 39456 h 1330017"/>
              <a:gd name="connsiteX5" fmla="*/ 2201663 w 2201663"/>
              <a:gd name="connsiteY5" fmla="*/ 3945 h 1330017"/>
              <a:gd name="connsiteX0" fmla="*/ 0 w 2201663"/>
              <a:gd name="connsiteY0" fmla="*/ 1326718 h 1330017"/>
              <a:gd name="connsiteX1" fmla="*/ 381740 w 2201663"/>
              <a:gd name="connsiteY1" fmla="*/ 1291208 h 1330017"/>
              <a:gd name="connsiteX2" fmla="*/ 923278 w 2201663"/>
              <a:gd name="connsiteY2" fmla="*/ 1051510 h 1330017"/>
              <a:gd name="connsiteX3" fmla="*/ 1653594 w 2201663"/>
              <a:gd name="connsiteY3" fmla="*/ 403644 h 1330017"/>
              <a:gd name="connsiteX4" fmla="*/ 1935333 w 2201663"/>
              <a:gd name="connsiteY4" fmla="*/ 39456 h 1330017"/>
              <a:gd name="connsiteX5" fmla="*/ 2201663 w 2201663"/>
              <a:gd name="connsiteY5" fmla="*/ 3945 h 1330017"/>
              <a:gd name="connsiteX0" fmla="*/ 0 w 2201663"/>
              <a:gd name="connsiteY0" fmla="*/ 1349982 h 1353281"/>
              <a:gd name="connsiteX1" fmla="*/ 381740 w 2201663"/>
              <a:gd name="connsiteY1" fmla="*/ 1314472 h 1353281"/>
              <a:gd name="connsiteX2" fmla="*/ 923278 w 2201663"/>
              <a:gd name="connsiteY2" fmla="*/ 1074774 h 1353281"/>
              <a:gd name="connsiteX3" fmla="*/ 1653594 w 2201663"/>
              <a:gd name="connsiteY3" fmla="*/ 426908 h 1353281"/>
              <a:gd name="connsiteX4" fmla="*/ 1914312 w 2201663"/>
              <a:gd name="connsiteY4" fmla="*/ 20678 h 1353281"/>
              <a:gd name="connsiteX5" fmla="*/ 2201663 w 2201663"/>
              <a:gd name="connsiteY5" fmla="*/ 27209 h 1353281"/>
              <a:gd name="connsiteX0" fmla="*/ 0 w 2201663"/>
              <a:gd name="connsiteY0" fmla="*/ 1349982 h 1354068"/>
              <a:gd name="connsiteX1" fmla="*/ 381740 w 2201663"/>
              <a:gd name="connsiteY1" fmla="*/ 1314472 h 1354068"/>
              <a:gd name="connsiteX2" fmla="*/ 1101954 w 2201663"/>
              <a:gd name="connsiteY2" fmla="*/ 1053754 h 1354068"/>
              <a:gd name="connsiteX3" fmla="*/ 1653594 w 2201663"/>
              <a:gd name="connsiteY3" fmla="*/ 426908 h 1354068"/>
              <a:gd name="connsiteX4" fmla="*/ 1914312 w 2201663"/>
              <a:gd name="connsiteY4" fmla="*/ 20678 h 1354068"/>
              <a:gd name="connsiteX5" fmla="*/ 2201663 w 2201663"/>
              <a:gd name="connsiteY5" fmla="*/ 27209 h 1354068"/>
              <a:gd name="connsiteX0" fmla="*/ 0 w 2201663"/>
              <a:gd name="connsiteY0" fmla="*/ 1324814 h 1328900"/>
              <a:gd name="connsiteX1" fmla="*/ 381740 w 2201663"/>
              <a:gd name="connsiteY1" fmla="*/ 1289304 h 1328900"/>
              <a:gd name="connsiteX2" fmla="*/ 1101954 w 2201663"/>
              <a:gd name="connsiteY2" fmla="*/ 1028586 h 1328900"/>
              <a:gd name="connsiteX3" fmla="*/ 1653594 w 2201663"/>
              <a:gd name="connsiteY3" fmla="*/ 401740 h 1328900"/>
              <a:gd name="connsiteX4" fmla="*/ 1935333 w 2201663"/>
              <a:gd name="connsiteY4" fmla="*/ 48061 h 1328900"/>
              <a:gd name="connsiteX5" fmla="*/ 2201663 w 2201663"/>
              <a:gd name="connsiteY5" fmla="*/ 2041 h 1328900"/>
              <a:gd name="connsiteX0" fmla="*/ 0 w 2201663"/>
              <a:gd name="connsiteY0" fmla="*/ 1324814 h 1328900"/>
              <a:gd name="connsiteX1" fmla="*/ 381740 w 2201663"/>
              <a:gd name="connsiteY1" fmla="*/ 1289304 h 1328900"/>
              <a:gd name="connsiteX2" fmla="*/ 1101954 w 2201663"/>
              <a:gd name="connsiteY2" fmla="*/ 1028586 h 1328900"/>
              <a:gd name="connsiteX3" fmla="*/ 1653594 w 2201663"/>
              <a:gd name="connsiteY3" fmla="*/ 454292 h 1328900"/>
              <a:gd name="connsiteX4" fmla="*/ 1935333 w 2201663"/>
              <a:gd name="connsiteY4" fmla="*/ 48061 h 1328900"/>
              <a:gd name="connsiteX5" fmla="*/ 2201663 w 2201663"/>
              <a:gd name="connsiteY5" fmla="*/ 2041 h 1328900"/>
              <a:gd name="connsiteX0" fmla="*/ 0 w 2201663"/>
              <a:gd name="connsiteY0" fmla="*/ 1323615 h 1327701"/>
              <a:gd name="connsiteX1" fmla="*/ 381740 w 2201663"/>
              <a:gd name="connsiteY1" fmla="*/ 1288105 h 1327701"/>
              <a:gd name="connsiteX2" fmla="*/ 1101954 w 2201663"/>
              <a:gd name="connsiteY2" fmla="*/ 1027387 h 1327701"/>
              <a:gd name="connsiteX3" fmla="*/ 1653594 w 2201663"/>
              <a:gd name="connsiteY3" fmla="*/ 453093 h 1327701"/>
              <a:gd name="connsiteX4" fmla="*/ 1935333 w 2201663"/>
              <a:gd name="connsiteY4" fmla="*/ 67883 h 1327701"/>
              <a:gd name="connsiteX5" fmla="*/ 2201663 w 2201663"/>
              <a:gd name="connsiteY5" fmla="*/ 842 h 1327701"/>
              <a:gd name="connsiteX0" fmla="*/ 0 w 2201663"/>
              <a:gd name="connsiteY0" fmla="*/ 1323615 h 1331807"/>
              <a:gd name="connsiteX1" fmla="*/ 381740 w 2201663"/>
              <a:gd name="connsiteY1" fmla="*/ 1288105 h 1331807"/>
              <a:gd name="connsiteX2" fmla="*/ 1186036 w 2201663"/>
              <a:gd name="connsiteY2" fmla="*/ 943305 h 1331807"/>
              <a:gd name="connsiteX3" fmla="*/ 1653594 w 2201663"/>
              <a:gd name="connsiteY3" fmla="*/ 453093 h 1331807"/>
              <a:gd name="connsiteX4" fmla="*/ 1935333 w 2201663"/>
              <a:gd name="connsiteY4" fmla="*/ 67883 h 1331807"/>
              <a:gd name="connsiteX5" fmla="*/ 2201663 w 2201663"/>
              <a:gd name="connsiteY5" fmla="*/ 842 h 1331807"/>
              <a:gd name="connsiteX0" fmla="*/ 0 w 2201663"/>
              <a:gd name="connsiteY0" fmla="*/ 1323198 h 1331390"/>
              <a:gd name="connsiteX1" fmla="*/ 381740 w 2201663"/>
              <a:gd name="connsiteY1" fmla="*/ 1287688 h 1331390"/>
              <a:gd name="connsiteX2" fmla="*/ 1186036 w 2201663"/>
              <a:gd name="connsiteY2" fmla="*/ 942888 h 1331390"/>
              <a:gd name="connsiteX3" fmla="*/ 1653594 w 2201663"/>
              <a:gd name="connsiteY3" fmla="*/ 452676 h 1331390"/>
              <a:gd name="connsiteX4" fmla="*/ 1956354 w 2201663"/>
              <a:gd name="connsiteY4" fmla="*/ 98997 h 1331390"/>
              <a:gd name="connsiteX5" fmla="*/ 2201663 w 2201663"/>
              <a:gd name="connsiteY5" fmla="*/ 425 h 1331390"/>
              <a:gd name="connsiteX0" fmla="*/ 0 w 2201663"/>
              <a:gd name="connsiteY0" fmla="*/ 1323198 h 1330250"/>
              <a:gd name="connsiteX1" fmla="*/ 381740 w 2201663"/>
              <a:gd name="connsiteY1" fmla="*/ 1287688 h 1330250"/>
              <a:gd name="connsiteX2" fmla="*/ 1228078 w 2201663"/>
              <a:gd name="connsiteY2" fmla="*/ 963909 h 1330250"/>
              <a:gd name="connsiteX3" fmla="*/ 1653594 w 2201663"/>
              <a:gd name="connsiteY3" fmla="*/ 452676 h 1330250"/>
              <a:gd name="connsiteX4" fmla="*/ 1956354 w 2201663"/>
              <a:gd name="connsiteY4" fmla="*/ 98997 h 1330250"/>
              <a:gd name="connsiteX5" fmla="*/ 2201663 w 2201663"/>
              <a:gd name="connsiteY5" fmla="*/ 425 h 1330250"/>
              <a:gd name="connsiteX0" fmla="*/ 0 w 2201663"/>
              <a:gd name="connsiteY0" fmla="*/ 1323198 h 1330250"/>
              <a:gd name="connsiteX1" fmla="*/ 581437 w 2201663"/>
              <a:gd name="connsiteY1" fmla="*/ 1287688 h 1330250"/>
              <a:gd name="connsiteX2" fmla="*/ 1228078 w 2201663"/>
              <a:gd name="connsiteY2" fmla="*/ 963909 h 1330250"/>
              <a:gd name="connsiteX3" fmla="*/ 1653594 w 2201663"/>
              <a:gd name="connsiteY3" fmla="*/ 452676 h 1330250"/>
              <a:gd name="connsiteX4" fmla="*/ 1956354 w 2201663"/>
              <a:gd name="connsiteY4" fmla="*/ 98997 h 1330250"/>
              <a:gd name="connsiteX5" fmla="*/ 2201663 w 2201663"/>
              <a:gd name="connsiteY5" fmla="*/ 425 h 1330250"/>
              <a:gd name="connsiteX0" fmla="*/ 0 w 2201663"/>
              <a:gd name="connsiteY0" fmla="*/ 1323198 h 1323450"/>
              <a:gd name="connsiteX1" fmla="*/ 560416 w 2201663"/>
              <a:gd name="connsiteY1" fmla="*/ 1193095 h 1323450"/>
              <a:gd name="connsiteX2" fmla="*/ 1228078 w 2201663"/>
              <a:gd name="connsiteY2" fmla="*/ 963909 h 1323450"/>
              <a:gd name="connsiteX3" fmla="*/ 1653594 w 2201663"/>
              <a:gd name="connsiteY3" fmla="*/ 452676 h 1323450"/>
              <a:gd name="connsiteX4" fmla="*/ 1956354 w 2201663"/>
              <a:gd name="connsiteY4" fmla="*/ 98997 h 1323450"/>
              <a:gd name="connsiteX5" fmla="*/ 2201663 w 2201663"/>
              <a:gd name="connsiteY5" fmla="*/ 425 h 1323450"/>
              <a:gd name="connsiteX0" fmla="*/ 0 w 2201663"/>
              <a:gd name="connsiteY0" fmla="*/ 1323198 h 1323503"/>
              <a:gd name="connsiteX1" fmla="*/ 560416 w 2201663"/>
              <a:gd name="connsiteY1" fmla="*/ 1193095 h 1323503"/>
              <a:gd name="connsiteX2" fmla="*/ 1270119 w 2201663"/>
              <a:gd name="connsiteY2" fmla="*/ 879826 h 1323503"/>
              <a:gd name="connsiteX3" fmla="*/ 1653594 w 2201663"/>
              <a:gd name="connsiteY3" fmla="*/ 452676 h 1323503"/>
              <a:gd name="connsiteX4" fmla="*/ 1956354 w 2201663"/>
              <a:gd name="connsiteY4" fmla="*/ 98997 h 1323503"/>
              <a:gd name="connsiteX5" fmla="*/ 2201663 w 2201663"/>
              <a:gd name="connsiteY5" fmla="*/ 425 h 13235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201663" h="1323503">
                <a:moveTo>
                  <a:pt x="0" y="1323198"/>
                </a:moveTo>
                <a:cubicBezTo>
                  <a:pt x="113930" y="1328377"/>
                  <a:pt x="348729" y="1266990"/>
                  <a:pt x="560416" y="1193095"/>
                </a:cubicBezTo>
                <a:cubicBezTo>
                  <a:pt x="772103" y="1119200"/>
                  <a:pt x="1087923" y="1003229"/>
                  <a:pt x="1270119" y="879826"/>
                </a:cubicBezTo>
                <a:cubicBezTo>
                  <a:pt x="1452315" y="756423"/>
                  <a:pt x="1539222" y="582814"/>
                  <a:pt x="1653594" y="452676"/>
                </a:cubicBezTo>
                <a:cubicBezTo>
                  <a:pt x="1767967" y="322538"/>
                  <a:pt x="1872016" y="146345"/>
                  <a:pt x="1956354" y="98997"/>
                </a:cubicBezTo>
                <a:cubicBezTo>
                  <a:pt x="2040692" y="51649"/>
                  <a:pt x="2110667" y="-5494"/>
                  <a:pt x="2201663" y="42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520"/>
          </a:p>
        </p:txBody>
      </p:sp>
      <p:sp>
        <p:nvSpPr>
          <p:cNvPr id="36" name="Freihandform: Form 35">
            <a:extLst>
              <a:ext uri="{FF2B5EF4-FFF2-40B4-BE49-F238E27FC236}">
                <a16:creationId xmlns:a16="http://schemas.microsoft.com/office/drawing/2014/main" id="{953376B5-8E5D-4815-BFEF-21BC91DD197C}"/>
              </a:ext>
            </a:extLst>
          </p:cNvPr>
          <p:cNvSpPr/>
          <p:nvPr/>
        </p:nvSpPr>
        <p:spPr>
          <a:xfrm>
            <a:off x="5179366" y="1639071"/>
            <a:ext cx="1896948" cy="1184294"/>
          </a:xfrm>
          <a:custGeom>
            <a:avLst/>
            <a:gdLst>
              <a:gd name="connsiteX0" fmla="*/ 0 w 2246050"/>
              <a:gd name="connsiteY0" fmla="*/ 1387227 h 1417971"/>
              <a:gd name="connsiteX1" fmla="*/ 310718 w 2246050"/>
              <a:gd name="connsiteY1" fmla="*/ 1404982 h 1417971"/>
              <a:gd name="connsiteX2" fmla="*/ 630314 w 2246050"/>
              <a:gd name="connsiteY2" fmla="*/ 1218551 h 1417971"/>
              <a:gd name="connsiteX3" fmla="*/ 1562470 w 2246050"/>
              <a:gd name="connsiteY3" fmla="*/ 384050 h 1417971"/>
              <a:gd name="connsiteX4" fmla="*/ 1926454 w 2246050"/>
              <a:gd name="connsiteY4" fmla="*/ 46699 h 1417971"/>
              <a:gd name="connsiteX5" fmla="*/ 2246050 w 2246050"/>
              <a:gd name="connsiteY5" fmla="*/ 11188 h 1417971"/>
              <a:gd name="connsiteX0" fmla="*/ 0 w 2246050"/>
              <a:gd name="connsiteY0" fmla="*/ 1387227 h 1404739"/>
              <a:gd name="connsiteX1" fmla="*/ 426332 w 2246050"/>
              <a:gd name="connsiteY1" fmla="*/ 1383961 h 1404739"/>
              <a:gd name="connsiteX2" fmla="*/ 630314 w 2246050"/>
              <a:gd name="connsiteY2" fmla="*/ 1218551 h 1404739"/>
              <a:gd name="connsiteX3" fmla="*/ 1562470 w 2246050"/>
              <a:gd name="connsiteY3" fmla="*/ 384050 h 1404739"/>
              <a:gd name="connsiteX4" fmla="*/ 1926454 w 2246050"/>
              <a:gd name="connsiteY4" fmla="*/ 46699 h 1404739"/>
              <a:gd name="connsiteX5" fmla="*/ 2246050 w 2246050"/>
              <a:gd name="connsiteY5" fmla="*/ 11188 h 1404739"/>
              <a:gd name="connsiteX0" fmla="*/ 0 w 2246050"/>
              <a:gd name="connsiteY0" fmla="*/ 1387227 h 1412374"/>
              <a:gd name="connsiteX1" fmla="*/ 426332 w 2246050"/>
              <a:gd name="connsiteY1" fmla="*/ 1383961 h 1412374"/>
              <a:gd name="connsiteX2" fmla="*/ 682865 w 2246050"/>
              <a:gd name="connsiteY2" fmla="*/ 1102937 h 1412374"/>
              <a:gd name="connsiteX3" fmla="*/ 1562470 w 2246050"/>
              <a:gd name="connsiteY3" fmla="*/ 384050 h 1412374"/>
              <a:gd name="connsiteX4" fmla="*/ 1926454 w 2246050"/>
              <a:gd name="connsiteY4" fmla="*/ 46699 h 1412374"/>
              <a:gd name="connsiteX5" fmla="*/ 2246050 w 2246050"/>
              <a:gd name="connsiteY5" fmla="*/ 11188 h 1412374"/>
              <a:gd name="connsiteX0" fmla="*/ 0 w 2246050"/>
              <a:gd name="connsiteY0" fmla="*/ 1387227 h 1412374"/>
              <a:gd name="connsiteX1" fmla="*/ 426332 w 2246050"/>
              <a:gd name="connsiteY1" fmla="*/ 1383961 h 1412374"/>
              <a:gd name="connsiteX2" fmla="*/ 682865 w 2246050"/>
              <a:gd name="connsiteY2" fmla="*/ 1102937 h 1412374"/>
              <a:gd name="connsiteX3" fmla="*/ 1446856 w 2246050"/>
              <a:gd name="connsiteY3" fmla="*/ 373539 h 1412374"/>
              <a:gd name="connsiteX4" fmla="*/ 1926454 w 2246050"/>
              <a:gd name="connsiteY4" fmla="*/ 46699 h 1412374"/>
              <a:gd name="connsiteX5" fmla="*/ 2246050 w 2246050"/>
              <a:gd name="connsiteY5" fmla="*/ 11188 h 1412374"/>
              <a:gd name="connsiteX0" fmla="*/ 0 w 2246050"/>
              <a:gd name="connsiteY0" fmla="*/ 1387227 h 1402244"/>
              <a:gd name="connsiteX1" fmla="*/ 415821 w 2246050"/>
              <a:gd name="connsiteY1" fmla="*/ 1362940 h 1402244"/>
              <a:gd name="connsiteX2" fmla="*/ 682865 w 2246050"/>
              <a:gd name="connsiteY2" fmla="*/ 1102937 h 1402244"/>
              <a:gd name="connsiteX3" fmla="*/ 1446856 w 2246050"/>
              <a:gd name="connsiteY3" fmla="*/ 373539 h 1402244"/>
              <a:gd name="connsiteX4" fmla="*/ 1926454 w 2246050"/>
              <a:gd name="connsiteY4" fmla="*/ 46699 h 1402244"/>
              <a:gd name="connsiteX5" fmla="*/ 2246050 w 2246050"/>
              <a:gd name="connsiteY5" fmla="*/ 11188 h 14022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246050" h="1402244">
                <a:moveTo>
                  <a:pt x="0" y="1387227"/>
                </a:moveTo>
                <a:cubicBezTo>
                  <a:pt x="102833" y="1410161"/>
                  <a:pt x="302010" y="1410322"/>
                  <a:pt x="415821" y="1362940"/>
                </a:cubicBezTo>
                <a:cubicBezTo>
                  <a:pt x="529632" y="1315558"/>
                  <a:pt x="511026" y="1267837"/>
                  <a:pt x="682865" y="1102937"/>
                </a:cubicBezTo>
                <a:cubicBezTo>
                  <a:pt x="854704" y="938037"/>
                  <a:pt x="1239591" y="549579"/>
                  <a:pt x="1446856" y="373539"/>
                </a:cubicBezTo>
                <a:cubicBezTo>
                  <a:pt x="1654121" y="197499"/>
                  <a:pt x="1812524" y="108843"/>
                  <a:pt x="1926454" y="46699"/>
                </a:cubicBezTo>
                <a:cubicBezTo>
                  <a:pt x="2040384" y="-15445"/>
                  <a:pt x="2143217" y="-2129"/>
                  <a:pt x="2246050" y="11188"/>
                </a:cubicBezTo>
              </a:path>
            </a:pathLst>
          </a:custGeom>
          <a:noFill/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520"/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C2B4D928-0655-47C6-90C5-570869A38D9A}"/>
              </a:ext>
            </a:extLst>
          </p:cNvPr>
          <p:cNvSpPr txBox="1"/>
          <p:nvPr/>
        </p:nvSpPr>
        <p:spPr>
          <a:xfrm>
            <a:off x="5821948" y="3537345"/>
            <a:ext cx="829073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/>
              <a:t>time [d]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57DB9BCC-42B4-4B1A-B887-5AC25A6FE0D2}"/>
              </a:ext>
            </a:extLst>
          </p:cNvPr>
          <p:cNvSpPr txBox="1"/>
          <p:nvPr/>
        </p:nvSpPr>
        <p:spPr>
          <a:xfrm rot="16200000">
            <a:off x="3887115" y="2016251"/>
            <a:ext cx="1450333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 err="1"/>
              <a:t>fresh</a:t>
            </a:r>
            <a:r>
              <a:rPr lang="de-DE" sz="1520" b="1" dirty="0"/>
              <a:t> </a:t>
            </a:r>
            <a:r>
              <a:rPr lang="de-DE" sz="1520" b="1" dirty="0" err="1"/>
              <a:t>weight</a:t>
            </a:r>
            <a:r>
              <a:rPr lang="de-DE" sz="1520" b="1" dirty="0"/>
              <a:t> [g]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4B4DB4D1-CAB6-4EF5-B2C1-893958D9924D}"/>
              </a:ext>
            </a:extLst>
          </p:cNvPr>
          <p:cNvSpPr txBox="1"/>
          <p:nvPr/>
        </p:nvSpPr>
        <p:spPr>
          <a:xfrm rot="5400000">
            <a:off x="7153513" y="2067710"/>
            <a:ext cx="1309076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>
                <a:solidFill>
                  <a:schemeClr val="bg1">
                    <a:lumMod val="65000"/>
                  </a:schemeClr>
                </a:solidFill>
              </a:rPr>
              <a:t>dry </a:t>
            </a:r>
            <a:r>
              <a:rPr lang="de-DE" sz="1520" b="1" dirty="0" err="1">
                <a:solidFill>
                  <a:schemeClr val="bg1">
                    <a:lumMod val="65000"/>
                  </a:schemeClr>
                </a:solidFill>
              </a:rPr>
              <a:t>weight</a:t>
            </a:r>
            <a:r>
              <a:rPr lang="de-DE" sz="1520" b="1" dirty="0">
                <a:solidFill>
                  <a:schemeClr val="bg1">
                    <a:lumMod val="65000"/>
                  </a:schemeClr>
                </a:solidFill>
              </a:rPr>
              <a:t> [g]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D23C70B8-0572-40CE-8626-15A51BBAA697}"/>
              </a:ext>
            </a:extLst>
          </p:cNvPr>
          <p:cNvSpPr txBox="1"/>
          <p:nvPr/>
        </p:nvSpPr>
        <p:spPr>
          <a:xfrm>
            <a:off x="5750658" y="2774499"/>
            <a:ext cx="955711" cy="2742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82" dirty="0" err="1"/>
              <a:t>fresh</a:t>
            </a:r>
            <a:r>
              <a:rPr lang="de-DE" sz="1182" dirty="0"/>
              <a:t> </a:t>
            </a:r>
            <a:r>
              <a:rPr lang="de-DE" sz="1182" dirty="0" err="1"/>
              <a:t>weight</a:t>
            </a:r>
            <a:endParaRPr lang="de-DE" sz="1182" dirty="0"/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8D7DEFA7-1DD0-40BF-A651-65B1FB258764}"/>
              </a:ext>
            </a:extLst>
          </p:cNvPr>
          <p:cNvSpPr txBox="1"/>
          <p:nvPr/>
        </p:nvSpPr>
        <p:spPr>
          <a:xfrm>
            <a:off x="5389478" y="1919434"/>
            <a:ext cx="843501" cy="2742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82" dirty="0">
                <a:solidFill>
                  <a:schemeClr val="bg1">
                    <a:lumMod val="50000"/>
                  </a:schemeClr>
                </a:solidFill>
              </a:rPr>
              <a:t>dry </a:t>
            </a:r>
            <a:r>
              <a:rPr lang="de-DE" sz="1182" dirty="0" err="1">
                <a:solidFill>
                  <a:schemeClr val="bg1">
                    <a:lumMod val="50000"/>
                  </a:schemeClr>
                </a:solidFill>
              </a:rPr>
              <a:t>weight</a:t>
            </a:r>
            <a:endParaRPr lang="de-DE" sz="1182" dirty="0">
              <a:solidFill>
                <a:schemeClr val="bg1">
                  <a:lumMod val="50000"/>
                </a:schemeClr>
              </a:solidFill>
            </a:endParaRPr>
          </a:p>
        </p:txBody>
      </p:sp>
      <p:graphicFrame>
        <p:nvGraphicFramePr>
          <p:cNvPr id="66" name="Diagramm 65">
            <a:extLst>
              <a:ext uri="{FF2B5EF4-FFF2-40B4-BE49-F238E27FC236}">
                <a16:creationId xmlns:a16="http://schemas.microsoft.com/office/drawing/2014/main" id="{A7815673-DF7D-4E60-B4D3-9D44FF696A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6830753"/>
              </p:ext>
            </p:extLst>
          </p:nvPr>
        </p:nvGraphicFramePr>
        <p:xfrm>
          <a:off x="1772887" y="1212754"/>
          <a:ext cx="2563395" cy="2316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7" name="Textfeld 66">
            <a:extLst>
              <a:ext uri="{FF2B5EF4-FFF2-40B4-BE49-F238E27FC236}">
                <a16:creationId xmlns:a16="http://schemas.microsoft.com/office/drawing/2014/main" id="{706582E6-218E-4B8D-8894-88F425D83556}"/>
              </a:ext>
            </a:extLst>
          </p:cNvPr>
          <p:cNvSpPr txBox="1"/>
          <p:nvPr/>
        </p:nvSpPr>
        <p:spPr>
          <a:xfrm>
            <a:off x="2364280" y="3468663"/>
            <a:ext cx="1552733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 err="1"/>
              <a:t>number</a:t>
            </a:r>
            <a:r>
              <a:rPr lang="de-DE" sz="1520" b="1" dirty="0"/>
              <a:t> </a:t>
            </a:r>
            <a:r>
              <a:rPr lang="de-DE" sz="1520" b="1" dirty="0" err="1"/>
              <a:t>of</a:t>
            </a:r>
            <a:r>
              <a:rPr lang="de-DE" sz="1520" b="1" dirty="0"/>
              <a:t> </a:t>
            </a:r>
            <a:r>
              <a:rPr lang="de-DE" sz="1520" b="1" dirty="0" err="1"/>
              <a:t>cycles</a:t>
            </a:r>
            <a:endParaRPr lang="de-DE" sz="1520" b="1" dirty="0"/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A056DB35-005D-4544-90C1-75E5E24900E0}"/>
              </a:ext>
            </a:extLst>
          </p:cNvPr>
          <p:cNvSpPr txBox="1"/>
          <p:nvPr/>
        </p:nvSpPr>
        <p:spPr>
          <a:xfrm rot="16200000">
            <a:off x="801680" y="2076721"/>
            <a:ext cx="1250214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 err="1"/>
              <a:t>growth</a:t>
            </a:r>
            <a:r>
              <a:rPr lang="de-DE" sz="1520" b="1" dirty="0"/>
              <a:t> </a:t>
            </a:r>
            <a:r>
              <a:rPr lang="de-DE" sz="1520" b="1" dirty="0" err="1"/>
              <a:t>index</a:t>
            </a:r>
            <a:endParaRPr lang="de-DE" sz="1520" b="1" dirty="0"/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ADE9B62E-7F03-4CB8-9B5E-080867740D04}"/>
              </a:ext>
            </a:extLst>
          </p:cNvPr>
          <p:cNvSpPr txBox="1"/>
          <p:nvPr/>
        </p:nvSpPr>
        <p:spPr>
          <a:xfrm>
            <a:off x="4459996" y="1168032"/>
            <a:ext cx="341760" cy="4042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27" b="1" dirty="0"/>
              <a:t>B</a:t>
            </a:r>
            <a:endParaRPr lang="en-GB" sz="2027" b="1" dirty="0"/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8E51ED5D-1815-4F52-BE15-2FC9B631E279}"/>
              </a:ext>
            </a:extLst>
          </p:cNvPr>
          <p:cNvSpPr txBox="1"/>
          <p:nvPr/>
        </p:nvSpPr>
        <p:spPr>
          <a:xfrm>
            <a:off x="1263867" y="1171875"/>
            <a:ext cx="341760" cy="4042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27" b="1" dirty="0"/>
              <a:t>A</a:t>
            </a:r>
            <a:endParaRPr lang="en-GB" sz="2027" b="1" dirty="0"/>
          </a:p>
        </p:txBody>
      </p:sp>
      <p:graphicFrame>
        <p:nvGraphicFramePr>
          <p:cNvPr id="25" name="Diagramm 24">
            <a:extLst>
              <a:ext uri="{FF2B5EF4-FFF2-40B4-BE49-F238E27FC236}">
                <a16:creationId xmlns:a16="http://schemas.microsoft.com/office/drawing/2014/main" id="{3864892F-63E8-4D5D-A162-D2BE019F2B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7767374"/>
              </p:ext>
            </p:extLst>
          </p:nvPr>
        </p:nvGraphicFramePr>
        <p:xfrm>
          <a:off x="8287897" y="1193889"/>
          <a:ext cx="2643350" cy="23168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6" name="Textfeld 25">
            <a:extLst>
              <a:ext uri="{FF2B5EF4-FFF2-40B4-BE49-F238E27FC236}">
                <a16:creationId xmlns:a16="http://schemas.microsoft.com/office/drawing/2014/main" id="{25CD6B0C-32C1-418C-B383-A0F55A274F5B}"/>
              </a:ext>
            </a:extLst>
          </p:cNvPr>
          <p:cNvSpPr txBox="1"/>
          <p:nvPr/>
        </p:nvSpPr>
        <p:spPr>
          <a:xfrm rot="16200000">
            <a:off x="7391348" y="1972120"/>
            <a:ext cx="1471878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/>
              <a:t>PCV [ml</a:t>
            </a:r>
            <a:r>
              <a:rPr lang="de-DE" sz="1520" b="1" baseline="30000" dirty="0"/>
              <a:t>.</a:t>
            </a:r>
            <a:r>
              <a:rPr lang="de-DE" sz="1520" b="1" dirty="0"/>
              <a:t>10 ml</a:t>
            </a:r>
            <a:r>
              <a:rPr lang="de-DE" sz="1520" b="1" baseline="30000" dirty="0"/>
              <a:t>-1</a:t>
            </a:r>
            <a:r>
              <a:rPr lang="de-DE" sz="1520" b="1" dirty="0"/>
              <a:t>]</a:t>
            </a:r>
          </a:p>
        </p:txBody>
      </p:sp>
      <p:sp>
        <p:nvSpPr>
          <p:cNvPr id="4" name="Freihandform: Form 3">
            <a:extLst>
              <a:ext uri="{FF2B5EF4-FFF2-40B4-BE49-F238E27FC236}">
                <a16:creationId xmlns:a16="http://schemas.microsoft.com/office/drawing/2014/main" id="{5BFAD2E9-4515-48E7-AD9E-21D4E8722023}"/>
              </a:ext>
            </a:extLst>
          </p:cNvPr>
          <p:cNvSpPr/>
          <p:nvPr/>
        </p:nvSpPr>
        <p:spPr>
          <a:xfrm>
            <a:off x="8688700" y="1771067"/>
            <a:ext cx="1921035" cy="1177370"/>
          </a:xfrm>
          <a:custGeom>
            <a:avLst/>
            <a:gdLst>
              <a:gd name="connsiteX0" fmla="*/ 0 w 2298804"/>
              <a:gd name="connsiteY0" fmla="*/ 1392928 h 1403499"/>
              <a:gd name="connsiteX1" fmla="*/ 213360 w 2298804"/>
              <a:gd name="connsiteY1" fmla="*/ 1366258 h 1403499"/>
              <a:gd name="connsiteX2" fmla="*/ 624840 w 2298804"/>
              <a:gd name="connsiteY2" fmla="*/ 1088128 h 1403499"/>
              <a:gd name="connsiteX3" fmla="*/ 800100 w 2298804"/>
              <a:gd name="connsiteY3" fmla="*/ 1000498 h 1403499"/>
              <a:gd name="connsiteX4" fmla="*/ 1409700 w 2298804"/>
              <a:gd name="connsiteY4" fmla="*/ 977638 h 1403499"/>
              <a:gd name="connsiteX5" fmla="*/ 1821180 w 2298804"/>
              <a:gd name="connsiteY5" fmla="*/ 505198 h 1403499"/>
              <a:gd name="connsiteX6" fmla="*/ 2118360 w 2298804"/>
              <a:gd name="connsiteY6" fmla="*/ 112768 h 1403499"/>
              <a:gd name="connsiteX7" fmla="*/ 2286000 w 2298804"/>
              <a:gd name="connsiteY7" fmla="*/ 9898 h 1403499"/>
              <a:gd name="connsiteX8" fmla="*/ 2274570 w 2298804"/>
              <a:gd name="connsiteY8" fmla="*/ 9898 h 1403499"/>
              <a:gd name="connsiteX0" fmla="*/ 0 w 2298804"/>
              <a:gd name="connsiteY0" fmla="*/ 1392928 h 1406336"/>
              <a:gd name="connsiteX1" fmla="*/ 213360 w 2298804"/>
              <a:gd name="connsiteY1" fmla="*/ 1366258 h 1406336"/>
              <a:gd name="connsiteX2" fmla="*/ 678748 w 2298804"/>
              <a:gd name="connsiteY2" fmla="*/ 1038269 h 1406336"/>
              <a:gd name="connsiteX3" fmla="*/ 800100 w 2298804"/>
              <a:gd name="connsiteY3" fmla="*/ 1000498 h 1406336"/>
              <a:gd name="connsiteX4" fmla="*/ 1409700 w 2298804"/>
              <a:gd name="connsiteY4" fmla="*/ 977638 h 1406336"/>
              <a:gd name="connsiteX5" fmla="*/ 1821180 w 2298804"/>
              <a:gd name="connsiteY5" fmla="*/ 505198 h 1406336"/>
              <a:gd name="connsiteX6" fmla="*/ 2118360 w 2298804"/>
              <a:gd name="connsiteY6" fmla="*/ 112768 h 1406336"/>
              <a:gd name="connsiteX7" fmla="*/ 2286000 w 2298804"/>
              <a:gd name="connsiteY7" fmla="*/ 9898 h 1406336"/>
              <a:gd name="connsiteX8" fmla="*/ 2274570 w 2298804"/>
              <a:gd name="connsiteY8" fmla="*/ 9898 h 1406336"/>
              <a:gd name="connsiteX0" fmla="*/ 0 w 2298804"/>
              <a:gd name="connsiteY0" fmla="*/ 1392928 h 1406336"/>
              <a:gd name="connsiteX1" fmla="*/ 213360 w 2298804"/>
              <a:gd name="connsiteY1" fmla="*/ 1366258 h 1406336"/>
              <a:gd name="connsiteX2" fmla="*/ 678748 w 2298804"/>
              <a:gd name="connsiteY2" fmla="*/ 1038269 h 1406336"/>
              <a:gd name="connsiteX3" fmla="*/ 907916 w 2298804"/>
              <a:gd name="connsiteY3" fmla="*/ 1008168 h 1406336"/>
              <a:gd name="connsiteX4" fmla="*/ 1409700 w 2298804"/>
              <a:gd name="connsiteY4" fmla="*/ 977638 h 1406336"/>
              <a:gd name="connsiteX5" fmla="*/ 1821180 w 2298804"/>
              <a:gd name="connsiteY5" fmla="*/ 505198 h 1406336"/>
              <a:gd name="connsiteX6" fmla="*/ 2118360 w 2298804"/>
              <a:gd name="connsiteY6" fmla="*/ 112768 h 1406336"/>
              <a:gd name="connsiteX7" fmla="*/ 2286000 w 2298804"/>
              <a:gd name="connsiteY7" fmla="*/ 9898 h 1406336"/>
              <a:gd name="connsiteX8" fmla="*/ 2274570 w 2298804"/>
              <a:gd name="connsiteY8" fmla="*/ 9898 h 1406336"/>
              <a:gd name="connsiteX0" fmla="*/ 0 w 2298804"/>
              <a:gd name="connsiteY0" fmla="*/ 1392928 h 1403293"/>
              <a:gd name="connsiteX1" fmla="*/ 213360 w 2298804"/>
              <a:gd name="connsiteY1" fmla="*/ 1366258 h 1403293"/>
              <a:gd name="connsiteX2" fmla="*/ 613288 w 2298804"/>
              <a:gd name="connsiteY2" fmla="*/ 1091962 h 1403293"/>
              <a:gd name="connsiteX3" fmla="*/ 907916 w 2298804"/>
              <a:gd name="connsiteY3" fmla="*/ 1008168 h 1403293"/>
              <a:gd name="connsiteX4" fmla="*/ 1409700 w 2298804"/>
              <a:gd name="connsiteY4" fmla="*/ 977638 h 1403293"/>
              <a:gd name="connsiteX5" fmla="*/ 1821180 w 2298804"/>
              <a:gd name="connsiteY5" fmla="*/ 505198 h 1403293"/>
              <a:gd name="connsiteX6" fmla="*/ 2118360 w 2298804"/>
              <a:gd name="connsiteY6" fmla="*/ 112768 h 1403293"/>
              <a:gd name="connsiteX7" fmla="*/ 2286000 w 2298804"/>
              <a:gd name="connsiteY7" fmla="*/ 9898 h 1403293"/>
              <a:gd name="connsiteX8" fmla="*/ 2274570 w 2298804"/>
              <a:gd name="connsiteY8" fmla="*/ 9898 h 1403293"/>
              <a:gd name="connsiteX0" fmla="*/ 0 w 2298804"/>
              <a:gd name="connsiteY0" fmla="*/ 1392928 h 1403293"/>
              <a:gd name="connsiteX1" fmla="*/ 213360 w 2298804"/>
              <a:gd name="connsiteY1" fmla="*/ 1366258 h 1403293"/>
              <a:gd name="connsiteX2" fmla="*/ 613288 w 2298804"/>
              <a:gd name="connsiteY2" fmla="*/ 1091962 h 1403293"/>
              <a:gd name="connsiteX3" fmla="*/ 907916 w 2298804"/>
              <a:gd name="connsiteY3" fmla="*/ 1008168 h 1403293"/>
              <a:gd name="connsiteX4" fmla="*/ 1455907 w 2298804"/>
              <a:gd name="connsiteY4" fmla="*/ 939285 h 1403293"/>
              <a:gd name="connsiteX5" fmla="*/ 1821180 w 2298804"/>
              <a:gd name="connsiteY5" fmla="*/ 505198 h 1403293"/>
              <a:gd name="connsiteX6" fmla="*/ 2118360 w 2298804"/>
              <a:gd name="connsiteY6" fmla="*/ 112768 h 1403293"/>
              <a:gd name="connsiteX7" fmla="*/ 2286000 w 2298804"/>
              <a:gd name="connsiteY7" fmla="*/ 9898 h 1403293"/>
              <a:gd name="connsiteX8" fmla="*/ 2274570 w 2298804"/>
              <a:gd name="connsiteY8" fmla="*/ 9898 h 14032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298804" h="1403293">
                <a:moveTo>
                  <a:pt x="0" y="1392928"/>
                </a:moveTo>
                <a:cubicBezTo>
                  <a:pt x="54610" y="1404993"/>
                  <a:pt x="111145" y="1416419"/>
                  <a:pt x="213360" y="1366258"/>
                </a:cubicBezTo>
                <a:cubicBezTo>
                  <a:pt x="315575" y="1316097"/>
                  <a:pt x="497529" y="1151644"/>
                  <a:pt x="613288" y="1091962"/>
                </a:cubicBezTo>
                <a:cubicBezTo>
                  <a:pt x="729047" y="1032280"/>
                  <a:pt x="767480" y="1033614"/>
                  <a:pt x="907916" y="1008168"/>
                </a:cubicBezTo>
                <a:cubicBezTo>
                  <a:pt x="1048352" y="982722"/>
                  <a:pt x="1303696" y="1023113"/>
                  <a:pt x="1455907" y="939285"/>
                </a:cubicBezTo>
                <a:cubicBezTo>
                  <a:pt x="1608118" y="855457"/>
                  <a:pt x="1710771" y="642951"/>
                  <a:pt x="1821180" y="505198"/>
                </a:cubicBezTo>
                <a:cubicBezTo>
                  <a:pt x="1931589" y="367445"/>
                  <a:pt x="2040890" y="195318"/>
                  <a:pt x="2118360" y="112768"/>
                </a:cubicBezTo>
                <a:cubicBezTo>
                  <a:pt x="2195830" y="30218"/>
                  <a:pt x="2259965" y="27043"/>
                  <a:pt x="2286000" y="9898"/>
                </a:cubicBezTo>
                <a:cubicBezTo>
                  <a:pt x="2312035" y="-7247"/>
                  <a:pt x="2293302" y="1325"/>
                  <a:pt x="2274570" y="9898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520"/>
          </a:p>
        </p:txBody>
      </p:sp>
      <p:sp>
        <p:nvSpPr>
          <p:cNvPr id="5" name="Freihandform: Form 4">
            <a:extLst>
              <a:ext uri="{FF2B5EF4-FFF2-40B4-BE49-F238E27FC236}">
                <a16:creationId xmlns:a16="http://schemas.microsoft.com/office/drawing/2014/main" id="{C9113566-B21B-4B70-8B4D-EBFB56FB2D63}"/>
              </a:ext>
            </a:extLst>
          </p:cNvPr>
          <p:cNvSpPr/>
          <p:nvPr/>
        </p:nvSpPr>
        <p:spPr>
          <a:xfrm>
            <a:off x="8740196" y="1399302"/>
            <a:ext cx="1898298" cy="1217219"/>
          </a:xfrm>
          <a:custGeom>
            <a:avLst/>
            <a:gdLst>
              <a:gd name="connsiteX0" fmla="*/ 0 w 2297430"/>
              <a:gd name="connsiteY0" fmla="*/ 0 h 1287780"/>
              <a:gd name="connsiteX1" fmla="*/ 723900 w 2297430"/>
              <a:gd name="connsiteY1" fmla="*/ 377190 h 1287780"/>
              <a:gd name="connsiteX2" fmla="*/ 1055370 w 2297430"/>
              <a:gd name="connsiteY2" fmla="*/ 514350 h 1287780"/>
              <a:gd name="connsiteX3" fmla="*/ 1386840 w 2297430"/>
              <a:gd name="connsiteY3" fmla="*/ 697230 h 1287780"/>
              <a:gd name="connsiteX4" fmla="*/ 1775460 w 2297430"/>
              <a:gd name="connsiteY4" fmla="*/ 1173480 h 1287780"/>
              <a:gd name="connsiteX5" fmla="*/ 1954530 w 2297430"/>
              <a:gd name="connsiteY5" fmla="*/ 1264920 h 1287780"/>
              <a:gd name="connsiteX6" fmla="*/ 2297430 w 2297430"/>
              <a:gd name="connsiteY6" fmla="*/ 1287780 h 12877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97430" h="1287780">
                <a:moveTo>
                  <a:pt x="0" y="0"/>
                </a:moveTo>
                <a:cubicBezTo>
                  <a:pt x="276542" y="146685"/>
                  <a:pt x="548005" y="291465"/>
                  <a:pt x="723900" y="377190"/>
                </a:cubicBezTo>
                <a:cubicBezTo>
                  <a:pt x="899795" y="462915"/>
                  <a:pt x="944880" y="461010"/>
                  <a:pt x="1055370" y="514350"/>
                </a:cubicBezTo>
                <a:cubicBezTo>
                  <a:pt x="1165860" y="567690"/>
                  <a:pt x="1266825" y="587375"/>
                  <a:pt x="1386840" y="697230"/>
                </a:cubicBezTo>
                <a:cubicBezTo>
                  <a:pt x="1506855" y="807085"/>
                  <a:pt x="1680845" y="1078865"/>
                  <a:pt x="1775460" y="1173480"/>
                </a:cubicBezTo>
                <a:cubicBezTo>
                  <a:pt x="1870075" y="1268095"/>
                  <a:pt x="1867535" y="1245870"/>
                  <a:pt x="1954530" y="1264920"/>
                </a:cubicBezTo>
                <a:cubicBezTo>
                  <a:pt x="2041525" y="1283970"/>
                  <a:pt x="2169477" y="1285875"/>
                  <a:pt x="2297430" y="1287780"/>
                </a:cubicBezTo>
              </a:path>
            </a:pathLst>
          </a:custGeom>
          <a:noFill/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52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1B9DA8B1-6C45-47F0-BDA8-FB86A241D154}"/>
              </a:ext>
            </a:extLst>
          </p:cNvPr>
          <p:cNvSpPr txBox="1"/>
          <p:nvPr/>
        </p:nvSpPr>
        <p:spPr>
          <a:xfrm rot="5400000">
            <a:off x="10484383" y="2057253"/>
            <a:ext cx="1836721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 err="1">
                <a:solidFill>
                  <a:schemeClr val="bg1">
                    <a:lumMod val="65000"/>
                  </a:schemeClr>
                </a:solidFill>
              </a:rPr>
              <a:t>sugar</a:t>
            </a:r>
            <a:r>
              <a:rPr lang="de-DE" sz="1520" b="1" dirty="0">
                <a:solidFill>
                  <a:schemeClr val="bg1">
                    <a:lumMod val="65000"/>
                  </a:schemeClr>
                </a:solidFill>
              </a:rPr>
              <a:t> </a:t>
            </a:r>
            <a:r>
              <a:rPr lang="de-DE" sz="1520" b="1" dirty="0" err="1">
                <a:solidFill>
                  <a:schemeClr val="bg1">
                    <a:lumMod val="65000"/>
                  </a:schemeClr>
                </a:solidFill>
              </a:rPr>
              <a:t>content</a:t>
            </a:r>
            <a:r>
              <a:rPr lang="de-DE" sz="1520" b="1" dirty="0">
                <a:solidFill>
                  <a:schemeClr val="bg1">
                    <a:lumMod val="65000"/>
                  </a:schemeClr>
                </a:solidFill>
              </a:rPr>
              <a:t> [°Brix]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5785577-1F76-48F4-BFE0-F87154467AE6}"/>
              </a:ext>
            </a:extLst>
          </p:cNvPr>
          <p:cNvSpPr txBox="1"/>
          <p:nvPr/>
        </p:nvSpPr>
        <p:spPr>
          <a:xfrm>
            <a:off x="9358596" y="3525542"/>
            <a:ext cx="829073" cy="3262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20" b="1" dirty="0"/>
              <a:t>time [d]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C161EA41-1F04-4904-9901-E71BF96EE000}"/>
              </a:ext>
            </a:extLst>
          </p:cNvPr>
          <p:cNvSpPr txBox="1"/>
          <p:nvPr/>
        </p:nvSpPr>
        <p:spPr>
          <a:xfrm>
            <a:off x="7992094" y="1148304"/>
            <a:ext cx="322524" cy="4042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27" b="1" dirty="0"/>
              <a:t>C</a:t>
            </a:r>
            <a:endParaRPr lang="en-GB" sz="2027" b="1" dirty="0"/>
          </a:p>
        </p:txBody>
      </p:sp>
      <p:graphicFrame>
        <p:nvGraphicFramePr>
          <p:cNvPr id="35" name="Diagramm 34">
            <a:extLst>
              <a:ext uri="{FF2B5EF4-FFF2-40B4-BE49-F238E27FC236}">
                <a16:creationId xmlns:a16="http://schemas.microsoft.com/office/drawing/2014/main" id="{D69B53DD-E9DD-4B14-8FD0-2A4EF190D7D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4105680"/>
              </p:ext>
            </p:extLst>
          </p:nvPr>
        </p:nvGraphicFramePr>
        <p:xfrm>
          <a:off x="8659269" y="1202244"/>
          <a:ext cx="2595709" cy="1979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7" name="Textfeld 36">
            <a:extLst>
              <a:ext uri="{FF2B5EF4-FFF2-40B4-BE49-F238E27FC236}">
                <a16:creationId xmlns:a16="http://schemas.microsoft.com/office/drawing/2014/main" id="{FE88A1AF-53D9-467E-93EA-78644ED4731B}"/>
              </a:ext>
            </a:extLst>
          </p:cNvPr>
          <p:cNvSpPr txBox="1"/>
          <p:nvPr/>
        </p:nvSpPr>
        <p:spPr>
          <a:xfrm>
            <a:off x="9177536" y="2677117"/>
            <a:ext cx="429926" cy="2742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82" dirty="0"/>
              <a:t>PCV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A6B1A8BD-DCE5-498D-B32B-FB19280E8A12}"/>
              </a:ext>
            </a:extLst>
          </p:cNvPr>
          <p:cNvSpPr txBox="1"/>
          <p:nvPr/>
        </p:nvSpPr>
        <p:spPr>
          <a:xfrm>
            <a:off x="9380329" y="1508805"/>
            <a:ext cx="1037463" cy="2742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82" dirty="0" err="1">
                <a:solidFill>
                  <a:schemeClr val="bg1">
                    <a:lumMod val="50000"/>
                  </a:schemeClr>
                </a:solidFill>
              </a:rPr>
              <a:t>sugar</a:t>
            </a:r>
            <a:r>
              <a:rPr lang="de-DE" sz="1182" dirty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de-DE" sz="1182" dirty="0" err="1">
                <a:solidFill>
                  <a:schemeClr val="bg1">
                    <a:lumMod val="50000"/>
                  </a:schemeClr>
                </a:solidFill>
              </a:rPr>
              <a:t>content</a:t>
            </a:r>
            <a:endParaRPr lang="de-DE" sz="1182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1815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5</Words>
  <Application>Microsoft Office PowerPoint</Application>
  <PresentationFormat>Benutzerdefiniert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MLR</cp:lastModifiedBy>
  <cp:revision>10</cp:revision>
  <dcterms:created xsi:type="dcterms:W3CDTF">2020-09-23T14:30:23Z</dcterms:created>
  <dcterms:modified xsi:type="dcterms:W3CDTF">2022-04-13T08:55:21Z</dcterms:modified>
</cp:coreProperties>
</file>